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intzas, Konstantinos - SEG" initials="MKS" lastIdx="1" clrIdx="0">
    <p:extLst>
      <p:ext uri="{19B8F6BF-5375-455C-9EA6-DF929625EA0E}">
        <p15:presenceInfo xmlns:p15="http://schemas.microsoft.com/office/powerpoint/2012/main" userId="S::Mintzas.Konstantinos@sysmex-europe.com::8c131287-7383-4bd1-a38f-81a83fd893f4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9846C27-5E9A-4519-8735-B937006E8464}" v="1" dt="2023-11-16T09:28:35.71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836" autoAdjust="0"/>
    <p:restoredTop sz="94660"/>
  </p:normalViewPr>
  <p:slideViewPr>
    <p:cSldViewPr snapToGrid="0">
      <p:cViewPr varScale="1">
        <p:scale>
          <a:sx n="59" d="100"/>
          <a:sy n="59" d="100"/>
        </p:scale>
        <p:origin x="1733" y="5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Preukschas, Michael - SEG" userId="bcd6cc35-9a52-4bd0-973f-e67292d597ff" providerId="ADAL" clId="{8FFD0166-4BA9-4751-A9A7-92D22016AF22}"/>
    <pc:docChg chg="undo redo custSel modSld">
      <pc:chgData name="Preukschas, Michael - SEG" userId="bcd6cc35-9a52-4bd0-973f-e67292d597ff" providerId="ADAL" clId="{8FFD0166-4BA9-4751-A9A7-92D22016AF22}" dt="2023-06-19T13:00:43.678" v="93"/>
      <pc:docMkLst>
        <pc:docMk/>
      </pc:docMkLst>
      <pc:sldChg chg="modSp mod">
        <pc:chgData name="Preukschas, Michael - SEG" userId="bcd6cc35-9a52-4bd0-973f-e67292d597ff" providerId="ADAL" clId="{8FFD0166-4BA9-4751-A9A7-92D22016AF22}" dt="2023-06-19T13:00:43.678" v="93"/>
        <pc:sldMkLst>
          <pc:docMk/>
          <pc:sldMk cId="2737034867" sldId="267"/>
        </pc:sldMkLst>
        <pc:graphicFrameChg chg="mod modGraphic">
          <ac:chgData name="Preukschas, Michael - SEG" userId="bcd6cc35-9a52-4bd0-973f-e67292d597ff" providerId="ADAL" clId="{8FFD0166-4BA9-4751-A9A7-92D22016AF22}" dt="2023-06-19T13:00:43.678" v="93"/>
          <ac:graphicFrameMkLst>
            <pc:docMk/>
            <pc:sldMk cId="2737034867" sldId="267"/>
            <ac:graphicFrameMk id="2" creationId="{663FE9AD-53C3-432F-AED4-D5677A3816AC}"/>
          </ac:graphicFrameMkLst>
        </pc:graphicFrameChg>
      </pc:sldChg>
    </pc:docChg>
  </pc:docChgLst>
  <pc:docChgLst>
    <pc:chgData name="Mintzas, Konstantinos - SEG" userId="8c131287-7383-4bd1-a38f-81a83fd893f4" providerId="ADAL" clId="{0D250578-30A5-42D4-8C88-BF27776B7108}"/>
    <pc:docChg chg="undo custSel addSld delSld modSld sldOrd modMainMaster">
      <pc:chgData name="Mintzas, Konstantinos - SEG" userId="8c131287-7383-4bd1-a38f-81a83fd893f4" providerId="ADAL" clId="{0D250578-30A5-42D4-8C88-BF27776B7108}" dt="2023-06-26T09:03:21.751" v="6587" actId="790"/>
      <pc:docMkLst>
        <pc:docMk/>
      </pc:docMkLst>
      <pc:sldChg chg="addSp delSp modSp new mod modClrScheme chgLayout">
        <pc:chgData name="Mintzas, Konstantinos - SEG" userId="8c131287-7383-4bd1-a38f-81a83fd893f4" providerId="ADAL" clId="{0D250578-30A5-42D4-8C88-BF27776B7108}" dt="2023-06-01T08:53:40.223" v="2823" actId="2165"/>
        <pc:sldMkLst>
          <pc:docMk/>
          <pc:sldMk cId="488937180" sldId="256"/>
        </pc:sldMkLst>
        <pc:spChg chg="del">
          <ac:chgData name="Mintzas, Konstantinos - SEG" userId="8c131287-7383-4bd1-a38f-81a83fd893f4" providerId="ADAL" clId="{0D250578-30A5-42D4-8C88-BF27776B7108}" dt="2023-05-24T09:16:44.779" v="1" actId="700"/>
          <ac:spMkLst>
            <pc:docMk/>
            <pc:sldMk cId="488937180" sldId="256"/>
            <ac:spMk id="2" creationId="{75983DD6-B2D7-42BB-B43C-E7B2A13A1E5A}"/>
          </ac:spMkLst>
        </pc:spChg>
        <pc:spChg chg="del">
          <ac:chgData name="Mintzas, Konstantinos - SEG" userId="8c131287-7383-4bd1-a38f-81a83fd893f4" providerId="ADAL" clId="{0D250578-30A5-42D4-8C88-BF27776B7108}" dt="2023-05-24T09:16:44.779" v="1" actId="700"/>
          <ac:spMkLst>
            <pc:docMk/>
            <pc:sldMk cId="488937180" sldId="256"/>
            <ac:spMk id="3" creationId="{7AD08067-5E4B-45A7-8CE4-EBCC7F29E2E0}"/>
          </ac:spMkLst>
        </pc:spChg>
        <pc:spChg chg="add mod">
          <ac:chgData name="Mintzas, Konstantinos - SEG" userId="8c131287-7383-4bd1-a38f-81a83fd893f4" providerId="ADAL" clId="{0D250578-30A5-42D4-8C88-BF27776B7108}" dt="2023-05-24T09:32:07.495" v="825" actId="20577"/>
          <ac:spMkLst>
            <pc:docMk/>
            <pc:sldMk cId="488937180" sldId="256"/>
            <ac:spMk id="5" creationId="{514623FB-12B4-46F1-B649-27FAAA6D312F}"/>
          </ac:spMkLst>
        </pc:spChg>
        <pc:graphicFrameChg chg="add mod modGraphic">
          <ac:chgData name="Mintzas, Konstantinos - SEG" userId="8c131287-7383-4bd1-a38f-81a83fd893f4" providerId="ADAL" clId="{0D250578-30A5-42D4-8C88-BF27776B7108}" dt="2023-06-01T08:53:40.223" v="2823" actId="2165"/>
          <ac:graphicFrameMkLst>
            <pc:docMk/>
            <pc:sldMk cId="488937180" sldId="256"/>
            <ac:graphicFrameMk id="4" creationId="{19E6748F-51CE-40B0-B040-7DD69F36E478}"/>
          </ac:graphicFrameMkLst>
        </pc:graphicFrameChg>
      </pc:sldChg>
      <pc:sldChg chg="addSp delSp modSp new mod">
        <pc:chgData name="Mintzas, Konstantinos - SEG" userId="8c131287-7383-4bd1-a38f-81a83fd893f4" providerId="ADAL" clId="{0D250578-30A5-42D4-8C88-BF27776B7108}" dt="2023-06-05T11:20:48.834" v="5511" actId="14100"/>
        <pc:sldMkLst>
          <pc:docMk/>
          <pc:sldMk cId="823654777" sldId="257"/>
        </pc:sldMkLst>
        <pc:spChg chg="add del mod">
          <ac:chgData name="Mintzas, Konstantinos - SEG" userId="8c131287-7383-4bd1-a38f-81a83fd893f4" providerId="ADAL" clId="{0D250578-30A5-42D4-8C88-BF27776B7108}" dt="2023-06-05T11:14:06.330" v="5198" actId="21"/>
          <ac:spMkLst>
            <pc:docMk/>
            <pc:sldMk cId="823654777" sldId="257"/>
            <ac:spMk id="3" creationId="{B0BBAB24-CCAA-4A95-B179-80E9E4D11CB8}"/>
          </ac:spMkLst>
        </pc:spChg>
        <pc:spChg chg="add del mod">
          <ac:chgData name="Mintzas, Konstantinos - SEG" userId="8c131287-7383-4bd1-a38f-81a83fd893f4" providerId="ADAL" clId="{0D250578-30A5-42D4-8C88-BF27776B7108}" dt="2023-06-05T11:02:44.661" v="4931" actId="21"/>
          <ac:spMkLst>
            <pc:docMk/>
            <pc:sldMk cId="823654777" sldId="257"/>
            <ac:spMk id="6" creationId="{E615D7E1-45D1-4CB2-B61D-5A1B290DB85F}"/>
          </ac:spMkLst>
        </pc:spChg>
        <pc:spChg chg="add mod">
          <ac:chgData name="Mintzas, Konstantinos - SEG" userId="8c131287-7383-4bd1-a38f-81a83fd893f4" providerId="ADAL" clId="{0D250578-30A5-42D4-8C88-BF27776B7108}" dt="2023-06-05T11:14:24.971" v="5203"/>
          <ac:spMkLst>
            <pc:docMk/>
            <pc:sldMk cId="823654777" sldId="257"/>
            <ac:spMk id="8" creationId="{F2A1995C-8C83-447D-BA57-6F9B0D663DE8}"/>
          </ac:spMkLst>
        </pc:spChg>
        <pc:graphicFrameChg chg="add del mod">
          <ac:chgData name="Mintzas, Konstantinos - SEG" userId="8c131287-7383-4bd1-a38f-81a83fd893f4" providerId="ADAL" clId="{0D250578-30A5-42D4-8C88-BF27776B7108}" dt="2023-05-24T09:34:03.909" v="829" actId="478"/>
          <ac:graphicFrameMkLst>
            <pc:docMk/>
            <pc:sldMk cId="823654777" sldId="257"/>
            <ac:graphicFrameMk id="2" creationId="{F120447E-2B1F-44B5-9876-C6E470122B20}"/>
          </ac:graphicFrameMkLst>
        </pc:graphicFrameChg>
        <pc:graphicFrameChg chg="add del mod modGraphic">
          <ac:chgData name="Mintzas, Konstantinos - SEG" userId="8c131287-7383-4bd1-a38f-81a83fd893f4" providerId="ADAL" clId="{0D250578-30A5-42D4-8C88-BF27776B7108}" dt="2023-06-05T11:14:06.330" v="5198" actId="21"/>
          <ac:graphicFrameMkLst>
            <pc:docMk/>
            <pc:sldMk cId="823654777" sldId="257"/>
            <ac:graphicFrameMk id="4" creationId="{FA45AA15-1F83-418F-8530-8F1EB172323A}"/>
          </ac:graphicFrameMkLst>
        </pc:graphicFrameChg>
        <pc:graphicFrameChg chg="add del mod modGraphic">
          <ac:chgData name="Mintzas, Konstantinos - SEG" userId="8c131287-7383-4bd1-a38f-81a83fd893f4" providerId="ADAL" clId="{0D250578-30A5-42D4-8C88-BF27776B7108}" dt="2023-06-05T11:02:44.661" v="4931" actId="21"/>
          <ac:graphicFrameMkLst>
            <pc:docMk/>
            <pc:sldMk cId="823654777" sldId="257"/>
            <ac:graphicFrameMk id="5" creationId="{806FDEA7-0926-460B-9683-21EA391A5A7B}"/>
          </ac:graphicFrameMkLst>
        </pc:graphicFrameChg>
        <pc:graphicFrameChg chg="add mod modGraphic">
          <ac:chgData name="Mintzas, Konstantinos - SEG" userId="8c131287-7383-4bd1-a38f-81a83fd893f4" providerId="ADAL" clId="{0D250578-30A5-42D4-8C88-BF27776B7108}" dt="2023-06-05T11:20:48.834" v="5511" actId="14100"/>
          <ac:graphicFrameMkLst>
            <pc:docMk/>
            <pc:sldMk cId="823654777" sldId="257"/>
            <ac:graphicFrameMk id="7" creationId="{42AC5A5C-0DBF-448A-B2B6-2104C2D3AA5D}"/>
          </ac:graphicFrameMkLst>
        </pc:graphicFrameChg>
      </pc:sldChg>
      <pc:sldChg chg="addSp modSp new mod">
        <pc:chgData name="Mintzas, Konstantinos - SEG" userId="8c131287-7383-4bd1-a38f-81a83fd893f4" providerId="ADAL" clId="{0D250578-30A5-42D4-8C88-BF27776B7108}" dt="2023-06-14T05:57:59.851" v="6162" actId="20577"/>
        <pc:sldMkLst>
          <pc:docMk/>
          <pc:sldMk cId="2346725106" sldId="258"/>
        </pc:sldMkLst>
        <pc:spChg chg="add mod">
          <ac:chgData name="Mintzas, Konstantinos - SEG" userId="8c131287-7383-4bd1-a38f-81a83fd893f4" providerId="ADAL" clId="{0D250578-30A5-42D4-8C88-BF27776B7108}" dt="2023-05-24T09:56:43.046" v="1729" actId="20577"/>
          <ac:spMkLst>
            <pc:docMk/>
            <pc:sldMk cId="2346725106" sldId="258"/>
            <ac:spMk id="2" creationId="{0EC7B67D-7798-4B42-8A08-520C694C9413}"/>
          </ac:spMkLst>
        </pc:spChg>
        <pc:graphicFrameChg chg="add mod modGraphic">
          <ac:chgData name="Mintzas, Konstantinos - SEG" userId="8c131287-7383-4bd1-a38f-81a83fd893f4" providerId="ADAL" clId="{0D250578-30A5-42D4-8C88-BF27776B7108}" dt="2023-06-14T05:57:59.851" v="6162" actId="20577"/>
          <ac:graphicFrameMkLst>
            <pc:docMk/>
            <pc:sldMk cId="2346725106" sldId="258"/>
            <ac:graphicFrameMk id="3" creationId="{65CE4B14-DFAE-452E-94E0-DE311C228A9F}"/>
          </ac:graphicFrameMkLst>
        </pc:graphicFrameChg>
      </pc:sldChg>
      <pc:sldChg chg="modSp add mod">
        <pc:chgData name="Mintzas, Konstantinos - SEG" userId="8c131287-7383-4bd1-a38f-81a83fd893f4" providerId="ADAL" clId="{0D250578-30A5-42D4-8C88-BF27776B7108}" dt="2023-06-05T09:39:46.512" v="3760" actId="20577"/>
        <pc:sldMkLst>
          <pc:docMk/>
          <pc:sldMk cId="903622025" sldId="259"/>
        </pc:sldMkLst>
        <pc:spChg chg="mod">
          <ac:chgData name="Mintzas, Konstantinos - SEG" userId="8c131287-7383-4bd1-a38f-81a83fd893f4" providerId="ADAL" clId="{0D250578-30A5-42D4-8C88-BF27776B7108}" dt="2023-05-24T11:13:06.428" v="1879" actId="20577"/>
          <ac:spMkLst>
            <pc:docMk/>
            <pc:sldMk cId="903622025" sldId="259"/>
            <ac:spMk id="2" creationId="{0EC7B67D-7798-4B42-8A08-520C694C9413}"/>
          </ac:spMkLst>
        </pc:spChg>
        <pc:graphicFrameChg chg="mod modGraphic">
          <ac:chgData name="Mintzas, Konstantinos - SEG" userId="8c131287-7383-4bd1-a38f-81a83fd893f4" providerId="ADAL" clId="{0D250578-30A5-42D4-8C88-BF27776B7108}" dt="2023-06-05T09:39:46.512" v="3760" actId="20577"/>
          <ac:graphicFrameMkLst>
            <pc:docMk/>
            <pc:sldMk cId="903622025" sldId="259"/>
            <ac:graphicFrameMk id="3" creationId="{65CE4B14-DFAE-452E-94E0-DE311C228A9F}"/>
          </ac:graphicFrameMkLst>
        </pc:graphicFrameChg>
      </pc:sldChg>
      <pc:sldChg chg="addSp delSp modSp new del mod">
        <pc:chgData name="Mintzas, Konstantinos - SEG" userId="8c131287-7383-4bd1-a38f-81a83fd893f4" providerId="ADAL" clId="{0D250578-30A5-42D4-8C88-BF27776B7108}" dt="2023-06-07T07:56:41.553" v="6128" actId="47"/>
        <pc:sldMkLst>
          <pc:docMk/>
          <pc:sldMk cId="2184490863" sldId="260"/>
        </pc:sldMkLst>
        <pc:spChg chg="add mod">
          <ac:chgData name="Mintzas, Konstantinos - SEG" userId="8c131287-7383-4bd1-a38f-81a83fd893f4" providerId="ADAL" clId="{0D250578-30A5-42D4-8C88-BF27776B7108}" dt="2023-06-06T08:01:47.789" v="5728" actId="20577"/>
          <ac:spMkLst>
            <pc:docMk/>
            <pc:sldMk cId="2184490863" sldId="260"/>
            <ac:spMk id="22" creationId="{5F39906B-6A65-487C-9D56-ABE467082CDA}"/>
          </ac:spMkLst>
        </pc:spChg>
        <pc:picChg chg="add del">
          <ac:chgData name="Mintzas, Konstantinos - SEG" userId="8c131287-7383-4bd1-a38f-81a83fd893f4" providerId="ADAL" clId="{0D250578-30A5-42D4-8C88-BF27776B7108}" dt="2023-05-26T05:26:22.878" v="1959" actId="478"/>
          <ac:picMkLst>
            <pc:docMk/>
            <pc:sldMk cId="2184490863" sldId="260"/>
            <ac:picMk id="3" creationId="{7C9E0F8F-F800-4315-A69C-B1601118B466}"/>
          </ac:picMkLst>
        </pc:picChg>
        <pc:picChg chg="add del mod">
          <ac:chgData name="Mintzas, Konstantinos - SEG" userId="8c131287-7383-4bd1-a38f-81a83fd893f4" providerId="ADAL" clId="{0D250578-30A5-42D4-8C88-BF27776B7108}" dt="2023-05-26T06:15:07.830" v="1976" actId="478"/>
          <ac:picMkLst>
            <pc:docMk/>
            <pc:sldMk cId="2184490863" sldId="260"/>
            <ac:picMk id="5" creationId="{7D9E9561-ADCF-40AE-A445-F91790310D25}"/>
          </ac:picMkLst>
        </pc:picChg>
        <pc:picChg chg="add del mod">
          <ac:chgData name="Mintzas, Konstantinos - SEG" userId="8c131287-7383-4bd1-a38f-81a83fd893f4" providerId="ADAL" clId="{0D250578-30A5-42D4-8C88-BF27776B7108}" dt="2023-05-26T06:15:07.830" v="1976" actId="478"/>
          <ac:picMkLst>
            <pc:docMk/>
            <pc:sldMk cId="2184490863" sldId="260"/>
            <ac:picMk id="6" creationId="{D8BFBD4D-D09E-4649-A215-7F23D4B439E1}"/>
          </ac:picMkLst>
        </pc:picChg>
        <pc:picChg chg="add del mod">
          <ac:chgData name="Mintzas, Konstantinos - SEG" userId="8c131287-7383-4bd1-a38f-81a83fd893f4" providerId="ADAL" clId="{0D250578-30A5-42D4-8C88-BF27776B7108}" dt="2023-05-26T06:15:07.830" v="1976" actId="478"/>
          <ac:picMkLst>
            <pc:docMk/>
            <pc:sldMk cId="2184490863" sldId="260"/>
            <ac:picMk id="7" creationId="{C844DA7E-708D-49BB-B268-05E1A3A2FC02}"/>
          </ac:picMkLst>
        </pc:picChg>
        <pc:picChg chg="add del mod">
          <ac:chgData name="Mintzas, Konstantinos - SEG" userId="8c131287-7383-4bd1-a38f-81a83fd893f4" providerId="ADAL" clId="{0D250578-30A5-42D4-8C88-BF27776B7108}" dt="2023-05-26T06:15:07.830" v="1976" actId="478"/>
          <ac:picMkLst>
            <pc:docMk/>
            <pc:sldMk cId="2184490863" sldId="260"/>
            <ac:picMk id="8" creationId="{17888B9D-B2DA-46AB-B08D-2802D912F5AD}"/>
          </ac:picMkLst>
        </pc:picChg>
        <pc:picChg chg="add mod">
          <ac:chgData name="Mintzas, Konstantinos - SEG" userId="8c131287-7383-4bd1-a38f-81a83fd893f4" providerId="ADAL" clId="{0D250578-30A5-42D4-8C88-BF27776B7108}" dt="2023-05-26T06:37:29.036" v="1984" actId="1076"/>
          <ac:picMkLst>
            <pc:docMk/>
            <pc:sldMk cId="2184490863" sldId="260"/>
            <ac:picMk id="9" creationId="{FD4645BD-1B98-41D7-A11A-17A612337EDA}"/>
          </ac:picMkLst>
        </pc:picChg>
        <pc:picChg chg="add mod">
          <ac:chgData name="Mintzas, Konstantinos - SEG" userId="8c131287-7383-4bd1-a38f-81a83fd893f4" providerId="ADAL" clId="{0D250578-30A5-42D4-8C88-BF27776B7108}" dt="2023-05-26T06:37:27.775" v="1983" actId="1076"/>
          <ac:picMkLst>
            <pc:docMk/>
            <pc:sldMk cId="2184490863" sldId="260"/>
            <ac:picMk id="10" creationId="{BB2FCB9F-79AB-44DE-A0C0-82CBC1A05144}"/>
          </ac:picMkLst>
        </pc:picChg>
        <pc:picChg chg="add mod">
          <ac:chgData name="Mintzas, Konstantinos - SEG" userId="8c131287-7383-4bd1-a38f-81a83fd893f4" providerId="ADAL" clId="{0D250578-30A5-42D4-8C88-BF27776B7108}" dt="2023-05-26T06:37:37.828" v="1988" actId="1076"/>
          <ac:picMkLst>
            <pc:docMk/>
            <pc:sldMk cId="2184490863" sldId="260"/>
            <ac:picMk id="11" creationId="{27A33AB3-F0D3-4B8C-AE85-3A5C1BB09F67}"/>
          </ac:picMkLst>
        </pc:picChg>
        <pc:picChg chg="add mod">
          <ac:chgData name="Mintzas, Konstantinos - SEG" userId="8c131287-7383-4bd1-a38f-81a83fd893f4" providerId="ADAL" clId="{0D250578-30A5-42D4-8C88-BF27776B7108}" dt="2023-05-26T06:37:44.327" v="1991" actId="14100"/>
          <ac:picMkLst>
            <pc:docMk/>
            <pc:sldMk cId="2184490863" sldId="260"/>
            <ac:picMk id="12" creationId="{C0BAFE0E-2527-4340-9732-0FC34E45AE30}"/>
          </ac:picMkLst>
        </pc:picChg>
        <pc:picChg chg="add del mod">
          <ac:chgData name="Mintzas, Konstantinos - SEG" userId="8c131287-7383-4bd1-a38f-81a83fd893f4" providerId="ADAL" clId="{0D250578-30A5-42D4-8C88-BF27776B7108}" dt="2023-06-06T08:01:40.521" v="5724" actId="478"/>
          <ac:picMkLst>
            <pc:docMk/>
            <pc:sldMk cId="2184490863" sldId="260"/>
            <ac:picMk id="13" creationId="{D9586D7B-18D6-4286-AA76-04F43A1203AC}"/>
          </ac:picMkLst>
        </pc:picChg>
        <pc:picChg chg="add del mod">
          <ac:chgData name="Mintzas, Konstantinos - SEG" userId="8c131287-7383-4bd1-a38f-81a83fd893f4" providerId="ADAL" clId="{0D250578-30A5-42D4-8C88-BF27776B7108}" dt="2023-06-06T08:01:40.521" v="5724" actId="478"/>
          <ac:picMkLst>
            <pc:docMk/>
            <pc:sldMk cId="2184490863" sldId="260"/>
            <ac:picMk id="14" creationId="{F42F8513-E616-445A-A06E-4A026934ADD8}"/>
          </ac:picMkLst>
        </pc:picChg>
        <pc:picChg chg="add del mod">
          <ac:chgData name="Mintzas, Konstantinos - SEG" userId="8c131287-7383-4bd1-a38f-81a83fd893f4" providerId="ADAL" clId="{0D250578-30A5-42D4-8C88-BF27776B7108}" dt="2023-06-06T08:01:40.521" v="5724" actId="478"/>
          <ac:picMkLst>
            <pc:docMk/>
            <pc:sldMk cId="2184490863" sldId="260"/>
            <ac:picMk id="15" creationId="{0653CC61-D53B-4EBC-99CB-1C574CADEBCF}"/>
          </ac:picMkLst>
        </pc:picChg>
        <pc:picChg chg="add del mod">
          <ac:chgData name="Mintzas, Konstantinos - SEG" userId="8c131287-7383-4bd1-a38f-81a83fd893f4" providerId="ADAL" clId="{0D250578-30A5-42D4-8C88-BF27776B7108}" dt="2023-06-06T08:01:40.521" v="5724" actId="478"/>
          <ac:picMkLst>
            <pc:docMk/>
            <pc:sldMk cId="2184490863" sldId="260"/>
            <ac:picMk id="16" creationId="{EA38E43F-545B-4215-A5B2-C43EA5AD4AAE}"/>
          </ac:picMkLst>
        </pc:picChg>
        <pc:picChg chg="add del mod">
          <ac:chgData name="Mintzas, Konstantinos - SEG" userId="8c131287-7383-4bd1-a38f-81a83fd893f4" providerId="ADAL" clId="{0D250578-30A5-42D4-8C88-BF27776B7108}" dt="2023-06-06T08:01:40.521" v="5724" actId="478"/>
          <ac:picMkLst>
            <pc:docMk/>
            <pc:sldMk cId="2184490863" sldId="260"/>
            <ac:picMk id="17" creationId="{F3267CB4-2E4E-4BB9-B669-4521566F902E}"/>
          </ac:picMkLst>
        </pc:picChg>
        <pc:picChg chg="add del mod">
          <ac:chgData name="Mintzas, Konstantinos - SEG" userId="8c131287-7383-4bd1-a38f-81a83fd893f4" providerId="ADAL" clId="{0D250578-30A5-42D4-8C88-BF27776B7108}" dt="2023-06-06T08:01:40.521" v="5724" actId="478"/>
          <ac:picMkLst>
            <pc:docMk/>
            <pc:sldMk cId="2184490863" sldId="260"/>
            <ac:picMk id="18" creationId="{2E03DD5A-E5C7-481C-8F3A-CD96004F8EFD}"/>
          </ac:picMkLst>
        </pc:picChg>
        <pc:picChg chg="add del mod">
          <ac:chgData name="Mintzas, Konstantinos - SEG" userId="8c131287-7383-4bd1-a38f-81a83fd893f4" providerId="ADAL" clId="{0D250578-30A5-42D4-8C88-BF27776B7108}" dt="2023-06-06T08:01:40.521" v="5724" actId="478"/>
          <ac:picMkLst>
            <pc:docMk/>
            <pc:sldMk cId="2184490863" sldId="260"/>
            <ac:picMk id="19" creationId="{23C5560C-5944-400D-B949-7FFDCDB5EF4E}"/>
          </ac:picMkLst>
        </pc:picChg>
        <pc:picChg chg="add del mod">
          <ac:chgData name="Mintzas, Konstantinos - SEG" userId="8c131287-7383-4bd1-a38f-81a83fd893f4" providerId="ADAL" clId="{0D250578-30A5-42D4-8C88-BF27776B7108}" dt="2023-06-06T08:01:40.521" v="5724" actId="478"/>
          <ac:picMkLst>
            <pc:docMk/>
            <pc:sldMk cId="2184490863" sldId="260"/>
            <ac:picMk id="20" creationId="{C48AC6CF-493F-49E6-9D9B-C87DBBB3CB6C}"/>
          </ac:picMkLst>
        </pc:picChg>
        <pc:picChg chg="add del mod">
          <ac:chgData name="Mintzas, Konstantinos - SEG" userId="8c131287-7383-4bd1-a38f-81a83fd893f4" providerId="ADAL" clId="{0D250578-30A5-42D4-8C88-BF27776B7108}" dt="2023-06-06T08:01:40.521" v="5724" actId="478"/>
          <ac:picMkLst>
            <pc:docMk/>
            <pc:sldMk cId="2184490863" sldId="260"/>
            <ac:picMk id="21" creationId="{D7704A0D-CEA1-440B-B200-9AF81A36D1EC}"/>
          </ac:picMkLst>
        </pc:picChg>
      </pc:sldChg>
      <pc:sldChg chg="addSp delSp modSp new mod">
        <pc:chgData name="Mintzas, Konstantinos - SEG" userId="8c131287-7383-4bd1-a38f-81a83fd893f4" providerId="ADAL" clId="{0D250578-30A5-42D4-8C88-BF27776B7108}" dt="2023-06-07T08:09:14.647" v="6135" actId="1076"/>
        <pc:sldMkLst>
          <pc:docMk/>
          <pc:sldMk cId="900528703" sldId="261"/>
        </pc:sldMkLst>
        <pc:spChg chg="add mod">
          <ac:chgData name="Mintzas, Konstantinos - SEG" userId="8c131287-7383-4bd1-a38f-81a83fd893f4" providerId="ADAL" clId="{0D250578-30A5-42D4-8C88-BF27776B7108}" dt="2023-06-01T06:14:06.843" v="2617" actId="20577"/>
          <ac:spMkLst>
            <pc:docMk/>
            <pc:sldMk cId="900528703" sldId="261"/>
            <ac:spMk id="2" creationId="{CACD1F2C-E15C-4C16-BE44-24A3E67BC1DD}"/>
          </ac:spMkLst>
        </pc:spChg>
        <pc:spChg chg="add mod">
          <ac:chgData name="Mintzas, Konstantinos - SEG" userId="8c131287-7383-4bd1-a38f-81a83fd893f4" providerId="ADAL" clId="{0D250578-30A5-42D4-8C88-BF27776B7108}" dt="2023-06-01T08:19:32.719" v="2647" actId="1076"/>
          <ac:spMkLst>
            <pc:docMk/>
            <pc:sldMk cId="900528703" sldId="261"/>
            <ac:spMk id="18" creationId="{5687D3CC-07F9-4AC4-A023-FA329C1DA7BB}"/>
          </ac:spMkLst>
        </pc:spChg>
        <pc:spChg chg="add mod">
          <ac:chgData name="Mintzas, Konstantinos - SEG" userId="8c131287-7383-4bd1-a38f-81a83fd893f4" providerId="ADAL" clId="{0D250578-30A5-42D4-8C88-BF27776B7108}" dt="2023-06-01T08:19:43.327" v="2648" actId="1076"/>
          <ac:spMkLst>
            <pc:docMk/>
            <pc:sldMk cId="900528703" sldId="261"/>
            <ac:spMk id="19" creationId="{6072331A-6E31-4887-AFFD-39D390006B8D}"/>
          </ac:spMkLst>
        </pc:spChg>
        <pc:spChg chg="add mod">
          <ac:chgData name="Mintzas, Konstantinos - SEG" userId="8c131287-7383-4bd1-a38f-81a83fd893f4" providerId="ADAL" clId="{0D250578-30A5-42D4-8C88-BF27776B7108}" dt="2023-06-01T08:19:50.023" v="2652" actId="20577"/>
          <ac:spMkLst>
            <pc:docMk/>
            <pc:sldMk cId="900528703" sldId="261"/>
            <ac:spMk id="21" creationId="{C85901FC-3DE0-4038-8225-5BAFC9EB5C2E}"/>
          </ac:spMkLst>
        </pc:spChg>
        <pc:spChg chg="add mod">
          <ac:chgData name="Mintzas, Konstantinos - SEG" userId="8c131287-7383-4bd1-a38f-81a83fd893f4" providerId="ADAL" clId="{0D250578-30A5-42D4-8C88-BF27776B7108}" dt="2023-06-01T08:19:59.454" v="2656" actId="20577"/>
          <ac:spMkLst>
            <pc:docMk/>
            <pc:sldMk cId="900528703" sldId="261"/>
            <ac:spMk id="23" creationId="{52924219-4AE0-491D-B360-023FF5F46A51}"/>
          </ac:spMkLst>
        </pc:spChg>
        <pc:spChg chg="add mod">
          <ac:chgData name="Mintzas, Konstantinos - SEG" userId="8c131287-7383-4bd1-a38f-81a83fd893f4" providerId="ADAL" clId="{0D250578-30A5-42D4-8C88-BF27776B7108}" dt="2023-06-01T08:20:01.854" v="2658" actId="20577"/>
          <ac:spMkLst>
            <pc:docMk/>
            <pc:sldMk cId="900528703" sldId="261"/>
            <ac:spMk id="25" creationId="{CFB1E133-C5BF-4313-B957-BBD9C873627B}"/>
          </ac:spMkLst>
        </pc:spChg>
        <pc:spChg chg="add del mod">
          <ac:chgData name="Mintzas, Konstantinos - SEG" userId="8c131287-7383-4bd1-a38f-81a83fd893f4" providerId="ADAL" clId="{0D250578-30A5-42D4-8C88-BF27776B7108}" dt="2023-06-01T08:20:23.779" v="2662" actId="478"/>
          <ac:spMkLst>
            <pc:docMk/>
            <pc:sldMk cId="900528703" sldId="261"/>
            <ac:spMk id="27" creationId="{BF1F20FA-6669-493E-B9EF-E98897ABC7E8}"/>
          </ac:spMkLst>
        </pc:spChg>
        <pc:picChg chg="add del mod">
          <ac:chgData name="Mintzas, Konstantinos - SEG" userId="8c131287-7383-4bd1-a38f-81a83fd893f4" providerId="ADAL" clId="{0D250578-30A5-42D4-8C88-BF27776B7108}" dt="2023-06-01T08:16:17.916" v="2642" actId="478"/>
          <ac:picMkLst>
            <pc:docMk/>
            <pc:sldMk cId="900528703" sldId="261"/>
            <ac:picMk id="4" creationId="{97E7853B-2DC4-44CB-A26B-D828BE03DFFD}"/>
          </ac:picMkLst>
        </pc:picChg>
        <pc:picChg chg="add mod ord">
          <ac:chgData name="Mintzas, Konstantinos - SEG" userId="8c131287-7383-4bd1-a38f-81a83fd893f4" providerId="ADAL" clId="{0D250578-30A5-42D4-8C88-BF27776B7108}" dt="2023-06-07T08:09:14.647" v="6135" actId="1076"/>
          <ac:picMkLst>
            <pc:docMk/>
            <pc:sldMk cId="900528703" sldId="261"/>
            <ac:picMk id="4" creationId="{B2D8FDFC-86EC-46FA-9969-CB91C8DC9966}"/>
          </ac:picMkLst>
        </pc:picChg>
        <pc:picChg chg="add del mod">
          <ac:chgData name="Mintzas, Konstantinos - SEG" userId="8c131287-7383-4bd1-a38f-81a83fd893f4" providerId="ADAL" clId="{0D250578-30A5-42D4-8C88-BF27776B7108}" dt="2023-06-01T06:05:44.630" v="2031" actId="478"/>
          <ac:picMkLst>
            <pc:docMk/>
            <pc:sldMk cId="900528703" sldId="261"/>
            <ac:picMk id="4" creationId="{CB9050D1-F8FD-4D68-8198-EE83E103B6FE}"/>
          </ac:picMkLst>
        </pc:picChg>
        <pc:picChg chg="add del mod">
          <ac:chgData name="Mintzas, Konstantinos - SEG" userId="8c131287-7383-4bd1-a38f-81a83fd893f4" providerId="ADAL" clId="{0D250578-30A5-42D4-8C88-BF27776B7108}" dt="2023-06-01T06:05:44.630" v="2031" actId="478"/>
          <ac:picMkLst>
            <pc:docMk/>
            <pc:sldMk cId="900528703" sldId="261"/>
            <ac:picMk id="6" creationId="{59202100-F460-4F1C-BA7A-4F9A7D69FAF4}"/>
          </ac:picMkLst>
        </pc:picChg>
        <pc:picChg chg="add del mod">
          <ac:chgData name="Mintzas, Konstantinos - SEG" userId="8c131287-7383-4bd1-a38f-81a83fd893f4" providerId="ADAL" clId="{0D250578-30A5-42D4-8C88-BF27776B7108}" dt="2023-06-01T08:16:17.916" v="2642" actId="478"/>
          <ac:picMkLst>
            <pc:docMk/>
            <pc:sldMk cId="900528703" sldId="261"/>
            <ac:picMk id="6" creationId="{CF341828-7B97-4083-A1A9-59ACE2283BA8}"/>
          </ac:picMkLst>
        </pc:picChg>
        <pc:picChg chg="add del mod">
          <ac:chgData name="Mintzas, Konstantinos - SEG" userId="8c131287-7383-4bd1-a38f-81a83fd893f4" providerId="ADAL" clId="{0D250578-30A5-42D4-8C88-BF27776B7108}" dt="2023-06-01T08:16:17.916" v="2642" actId="478"/>
          <ac:picMkLst>
            <pc:docMk/>
            <pc:sldMk cId="900528703" sldId="261"/>
            <ac:picMk id="8" creationId="{14C6CF21-4AB6-4E44-AB6A-F9DB6F0AF0FE}"/>
          </ac:picMkLst>
        </pc:picChg>
        <pc:picChg chg="add del mod">
          <ac:chgData name="Mintzas, Konstantinos - SEG" userId="8c131287-7383-4bd1-a38f-81a83fd893f4" providerId="ADAL" clId="{0D250578-30A5-42D4-8C88-BF27776B7108}" dt="2023-06-01T06:05:44.630" v="2031" actId="478"/>
          <ac:picMkLst>
            <pc:docMk/>
            <pc:sldMk cId="900528703" sldId="261"/>
            <ac:picMk id="8" creationId="{43D0B49E-482D-4CA9-B59A-83173310FCA6}"/>
          </ac:picMkLst>
        </pc:picChg>
        <pc:picChg chg="add del mod">
          <ac:chgData name="Mintzas, Konstantinos - SEG" userId="8c131287-7383-4bd1-a38f-81a83fd893f4" providerId="ADAL" clId="{0D250578-30A5-42D4-8C88-BF27776B7108}" dt="2023-06-01T06:05:44.630" v="2031" actId="478"/>
          <ac:picMkLst>
            <pc:docMk/>
            <pc:sldMk cId="900528703" sldId="261"/>
            <ac:picMk id="10" creationId="{6621B84A-E605-4D5D-8FCB-D405778990BF}"/>
          </ac:picMkLst>
        </pc:picChg>
        <pc:picChg chg="add del mod">
          <ac:chgData name="Mintzas, Konstantinos - SEG" userId="8c131287-7383-4bd1-a38f-81a83fd893f4" providerId="ADAL" clId="{0D250578-30A5-42D4-8C88-BF27776B7108}" dt="2023-06-01T08:16:17.916" v="2642" actId="478"/>
          <ac:picMkLst>
            <pc:docMk/>
            <pc:sldMk cId="900528703" sldId="261"/>
            <ac:picMk id="10" creationId="{B4D7A197-38A8-4B48-91EC-A194555A6E26}"/>
          </ac:picMkLst>
        </pc:picChg>
        <pc:picChg chg="add del mod">
          <ac:chgData name="Mintzas, Konstantinos - SEG" userId="8c131287-7383-4bd1-a38f-81a83fd893f4" providerId="ADAL" clId="{0D250578-30A5-42D4-8C88-BF27776B7108}" dt="2023-06-01T06:05:44.630" v="2031" actId="478"/>
          <ac:picMkLst>
            <pc:docMk/>
            <pc:sldMk cId="900528703" sldId="261"/>
            <ac:picMk id="12" creationId="{7C2F8E9A-0FFF-43EE-A18B-475CF3E3AEA3}"/>
          </ac:picMkLst>
        </pc:picChg>
        <pc:picChg chg="add del mod">
          <ac:chgData name="Mintzas, Konstantinos - SEG" userId="8c131287-7383-4bd1-a38f-81a83fd893f4" providerId="ADAL" clId="{0D250578-30A5-42D4-8C88-BF27776B7108}" dt="2023-06-01T08:16:17.916" v="2642" actId="478"/>
          <ac:picMkLst>
            <pc:docMk/>
            <pc:sldMk cId="900528703" sldId="261"/>
            <ac:picMk id="12" creationId="{E3B1F7EF-5F2D-4E72-AE66-CE94A7936A03}"/>
          </ac:picMkLst>
        </pc:picChg>
        <pc:picChg chg="add del mod">
          <ac:chgData name="Mintzas, Konstantinos - SEG" userId="8c131287-7383-4bd1-a38f-81a83fd893f4" providerId="ADAL" clId="{0D250578-30A5-42D4-8C88-BF27776B7108}" dt="2023-06-01T05:54:07.127" v="2026" actId="478"/>
          <ac:picMkLst>
            <pc:docMk/>
            <pc:sldMk cId="900528703" sldId="261"/>
            <ac:picMk id="14" creationId="{D530BD8D-5445-42F7-8867-6D70C15A7AF3}"/>
          </ac:picMkLst>
        </pc:picChg>
        <pc:picChg chg="add del mod">
          <ac:chgData name="Mintzas, Konstantinos - SEG" userId="8c131287-7383-4bd1-a38f-81a83fd893f4" providerId="ADAL" clId="{0D250578-30A5-42D4-8C88-BF27776B7108}" dt="2023-06-01T06:05:44.630" v="2031" actId="478"/>
          <ac:picMkLst>
            <pc:docMk/>
            <pc:sldMk cId="900528703" sldId="261"/>
            <ac:picMk id="16" creationId="{2FB61AF7-78A9-434F-8CBE-71076F993A13}"/>
          </ac:picMkLst>
        </pc:picChg>
        <pc:picChg chg="add del mod">
          <ac:chgData name="Mintzas, Konstantinos - SEG" userId="8c131287-7383-4bd1-a38f-81a83fd893f4" providerId="ADAL" clId="{0D250578-30A5-42D4-8C88-BF27776B7108}" dt="2023-06-01T06:08:54.294" v="2317" actId="478"/>
          <ac:picMkLst>
            <pc:docMk/>
            <pc:sldMk cId="900528703" sldId="261"/>
            <ac:picMk id="18" creationId="{DC033E61-3BF7-4EB2-9D59-D49B5452E3D9}"/>
          </ac:picMkLst>
        </pc:picChg>
        <pc:picChg chg="add mod">
          <ac:chgData name="Mintzas, Konstantinos - SEG" userId="8c131287-7383-4bd1-a38f-81a83fd893f4" providerId="ADAL" clId="{0D250578-30A5-42D4-8C88-BF27776B7108}" dt="2023-06-01T06:05:53.913" v="2035" actId="1076"/>
          <ac:picMkLst>
            <pc:docMk/>
            <pc:sldMk cId="900528703" sldId="261"/>
            <ac:picMk id="20" creationId="{0B838548-63E0-4876-AFAE-3B1A038925ED}"/>
          </ac:picMkLst>
        </pc:picChg>
        <pc:picChg chg="add mod">
          <ac:chgData name="Mintzas, Konstantinos - SEG" userId="8c131287-7383-4bd1-a38f-81a83fd893f4" providerId="ADAL" clId="{0D250578-30A5-42D4-8C88-BF27776B7108}" dt="2023-06-01T06:06:00.319" v="2037" actId="1076"/>
          <ac:picMkLst>
            <pc:docMk/>
            <pc:sldMk cId="900528703" sldId="261"/>
            <ac:picMk id="22" creationId="{49B15E61-9246-4344-8A9E-454BA47DCF6C}"/>
          </ac:picMkLst>
        </pc:picChg>
        <pc:picChg chg="add mod">
          <ac:chgData name="Mintzas, Konstantinos - SEG" userId="8c131287-7383-4bd1-a38f-81a83fd893f4" providerId="ADAL" clId="{0D250578-30A5-42D4-8C88-BF27776B7108}" dt="2023-06-01T06:06:02.575" v="2039" actId="1076"/>
          <ac:picMkLst>
            <pc:docMk/>
            <pc:sldMk cId="900528703" sldId="261"/>
            <ac:picMk id="24" creationId="{AC4764B6-D0A3-4575-BA1A-82B854C761D1}"/>
          </ac:picMkLst>
        </pc:picChg>
        <pc:picChg chg="add mod">
          <ac:chgData name="Mintzas, Konstantinos - SEG" userId="8c131287-7383-4bd1-a38f-81a83fd893f4" providerId="ADAL" clId="{0D250578-30A5-42D4-8C88-BF27776B7108}" dt="2023-06-01T06:10:21.462" v="2438" actId="1076"/>
          <ac:picMkLst>
            <pc:docMk/>
            <pc:sldMk cId="900528703" sldId="261"/>
            <ac:picMk id="26" creationId="{9406103A-7CA7-4A04-9EC3-CE1D2D89F15B}"/>
          </ac:picMkLst>
        </pc:picChg>
        <pc:picChg chg="add del mod">
          <ac:chgData name="Mintzas, Konstantinos - SEG" userId="8c131287-7383-4bd1-a38f-81a83fd893f4" providerId="ADAL" clId="{0D250578-30A5-42D4-8C88-BF27776B7108}" dt="2023-06-07T08:09:09.315" v="6134" actId="478"/>
          <ac:picMkLst>
            <pc:docMk/>
            <pc:sldMk cId="900528703" sldId="261"/>
            <ac:picMk id="28" creationId="{885BB825-3F93-4EDE-8315-5C844462176F}"/>
          </ac:picMkLst>
        </pc:picChg>
      </pc:sldChg>
      <pc:sldChg chg="modSp add del mod">
        <pc:chgData name="Mintzas, Konstantinos - SEG" userId="8c131287-7383-4bd1-a38f-81a83fd893f4" providerId="ADAL" clId="{0D250578-30A5-42D4-8C88-BF27776B7108}" dt="2023-05-26T06:05:30.995" v="1965" actId="47"/>
        <pc:sldMkLst>
          <pc:docMk/>
          <pc:sldMk cId="1818071622" sldId="261"/>
        </pc:sldMkLst>
        <pc:graphicFrameChg chg="mod modGraphic">
          <ac:chgData name="Mintzas, Konstantinos - SEG" userId="8c131287-7383-4bd1-a38f-81a83fd893f4" providerId="ADAL" clId="{0D250578-30A5-42D4-8C88-BF27776B7108}" dt="2023-05-26T06:05:19.971" v="1964" actId="1076"/>
          <ac:graphicFrameMkLst>
            <pc:docMk/>
            <pc:sldMk cId="1818071622" sldId="261"/>
            <ac:graphicFrameMk id="3" creationId="{65CE4B14-DFAE-452E-94E0-DE311C228A9F}"/>
          </ac:graphicFrameMkLst>
        </pc:graphicFrameChg>
      </pc:sldChg>
      <pc:sldChg chg="addSp delSp modSp new mod">
        <pc:chgData name="Mintzas, Konstantinos - SEG" userId="8c131287-7383-4bd1-a38f-81a83fd893f4" providerId="ADAL" clId="{0D250578-30A5-42D4-8C88-BF27776B7108}" dt="2023-06-05T12:34:52.680" v="5698" actId="1076"/>
        <pc:sldMkLst>
          <pc:docMk/>
          <pc:sldMk cId="3393704244" sldId="262"/>
        </pc:sldMkLst>
        <pc:spChg chg="add mod">
          <ac:chgData name="Mintzas, Konstantinos - SEG" userId="8c131287-7383-4bd1-a38f-81a83fd893f4" providerId="ADAL" clId="{0D250578-30A5-42D4-8C88-BF27776B7108}" dt="2023-06-05T09:34:41.295" v="3734" actId="1076"/>
          <ac:spMkLst>
            <pc:docMk/>
            <pc:sldMk cId="3393704244" sldId="262"/>
            <ac:spMk id="2" creationId="{88AFF230-1DA5-46F7-BBA8-01E209F1227E}"/>
          </ac:spMkLst>
        </pc:spChg>
        <pc:spChg chg="add mod">
          <ac:chgData name="Mintzas, Konstantinos - SEG" userId="8c131287-7383-4bd1-a38f-81a83fd893f4" providerId="ADAL" clId="{0D250578-30A5-42D4-8C88-BF27776B7108}" dt="2023-06-01T08:20:20.219" v="2661"/>
          <ac:spMkLst>
            <pc:docMk/>
            <pc:sldMk cId="3393704244" sldId="262"/>
            <ac:spMk id="3" creationId="{20DBA63B-AF80-4CD1-A3FC-B03180DC51A4}"/>
          </ac:spMkLst>
        </pc:spChg>
        <pc:spChg chg="add mod">
          <ac:chgData name="Mintzas, Konstantinos - SEG" userId="8c131287-7383-4bd1-a38f-81a83fd893f4" providerId="ADAL" clId="{0D250578-30A5-42D4-8C88-BF27776B7108}" dt="2023-06-01T10:09:54.341" v="2864" actId="552"/>
          <ac:spMkLst>
            <pc:docMk/>
            <pc:sldMk cId="3393704244" sldId="262"/>
            <ac:spMk id="4" creationId="{C45C884E-D814-45CB-BBC7-2834EE6C3409}"/>
          </ac:spMkLst>
        </pc:spChg>
        <pc:spChg chg="add mod">
          <ac:chgData name="Mintzas, Konstantinos - SEG" userId="8c131287-7383-4bd1-a38f-81a83fd893f4" providerId="ADAL" clId="{0D250578-30A5-42D4-8C88-BF27776B7108}" dt="2023-06-01T10:09:48.443" v="2863" actId="553"/>
          <ac:spMkLst>
            <pc:docMk/>
            <pc:sldMk cId="3393704244" sldId="262"/>
            <ac:spMk id="5" creationId="{B5B40938-5CF7-4046-A7DE-CE3D8CE9E0B5}"/>
          </ac:spMkLst>
        </pc:spChg>
        <pc:spChg chg="add mod">
          <ac:chgData name="Mintzas, Konstantinos - SEG" userId="8c131287-7383-4bd1-a38f-81a83fd893f4" providerId="ADAL" clId="{0D250578-30A5-42D4-8C88-BF27776B7108}" dt="2023-06-01T08:20:20.219" v="2661"/>
          <ac:spMkLst>
            <pc:docMk/>
            <pc:sldMk cId="3393704244" sldId="262"/>
            <ac:spMk id="6" creationId="{1636557C-0AC2-4E7C-A91A-338305DA0D84}"/>
          </ac:spMkLst>
        </pc:spChg>
        <pc:spChg chg="add mod">
          <ac:chgData name="Mintzas, Konstantinos - SEG" userId="8c131287-7383-4bd1-a38f-81a83fd893f4" providerId="ADAL" clId="{0D250578-30A5-42D4-8C88-BF27776B7108}" dt="2023-06-01T10:09:54.341" v="2864" actId="552"/>
          <ac:spMkLst>
            <pc:docMk/>
            <pc:sldMk cId="3393704244" sldId="262"/>
            <ac:spMk id="7" creationId="{8E977409-F107-40B1-B039-BFCCE9FFA56B}"/>
          </ac:spMkLst>
        </pc:spChg>
        <pc:spChg chg="add mod">
          <ac:chgData name="Mintzas, Konstantinos - SEG" userId="8c131287-7383-4bd1-a38f-81a83fd893f4" providerId="ADAL" clId="{0D250578-30A5-42D4-8C88-BF27776B7108}" dt="2023-06-01T10:09:48.443" v="2863" actId="553"/>
          <ac:spMkLst>
            <pc:docMk/>
            <pc:sldMk cId="3393704244" sldId="262"/>
            <ac:spMk id="8" creationId="{EC7AEE36-1628-462F-93D4-70313815AA22}"/>
          </ac:spMkLst>
        </pc:spChg>
        <pc:spChg chg="add mod">
          <ac:chgData name="Mintzas, Konstantinos - SEG" userId="8c131287-7383-4bd1-a38f-81a83fd893f4" providerId="ADAL" clId="{0D250578-30A5-42D4-8C88-BF27776B7108}" dt="2023-06-01T08:20:37.781" v="2666" actId="20577"/>
          <ac:spMkLst>
            <pc:docMk/>
            <pc:sldMk cId="3393704244" sldId="262"/>
            <ac:spMk id="9" creationId="{51A057FB-5CEF-4EA3-A40F-0734F7C09280}"/>
          </ac:spMkLst>
        </pc:spChg>
        <pc:spChg chg="add mod">
          <ac:chgData name="Mintzas, Konstantinos - SEG" userId="8c131287-7383-4bd1-a38f-81a83fd893f4" providerId="ADAL" clId="{0D250578-30A5-42D4-8C88-BF27776B7108}" dt="2023-06-01T10:09:54.341" v="2864" actId="552"/>
          <ac:spMkLst>
            <pc:docMk/>
            <pc:sldMk cId="3393704244" sldId="262"/>
            <ac:spMk id="10" creationId="{7CCE2600-810D-4727-A95F-BE49C4C8022F}"/>
          </ac:spMkLst>
        </pc:spChg>
        <pc:spChg chg="add mod">
          <ac:chgData name="Mintzas, Konstantinos - SEG" userId="8c131287-7383-4bd1-a38f-81a83fd893f4" providerId="ADAL" clId="{0D250578-30A5-42D4-8C88-BF27776B7108}" dt="2023-06-01T10:09:48.443" v="2863" actId="553"/>
          <ac:spMkLst>
            <pc:docMk/>
            <pc:sldMk cId="3393704244" sldId="262"/>
            <ac:spMk id="11" creationId="{E87E30D9-2583-4C85-872B-62410D707223}"/>
          </ac:spMkLst>
        </pc:spChg>
        <pc:picChg chg="add del mod ord">
          <ac:chgData name="Mintzas, Konstantinos - SEG" userId="8c131287-7383-4bd1-a38f-81a83fd893f4" providerId="ADAL" clId="{0D250578-30A5-42D4-8C88-BF27776B7108}" dt="2023-06-01T08:42:49.708" v="2685" actId="478"/>
          <ac:picMkLst>
            <pc:docMk/>
            <pc:sldMk cId="3393704244" sldId="262"/>
            <ac:picMk id="13" creationId="{48960926-2937-424F-9CBF-36B7672BB788}"/>
          </ac:picMkLst>
        </pc:picChg>
        <pc:picChg chg="add del mod ord">
          <ac:chgData name="Mintzas, Konstantinos - SEG" userId="8c131287-7383-4bd1-a38f-81a83fd893f4" providerId="ADAL" clId="{0D250578-30A5-42D4-8C88-BF27776B7108}" dt="2023-06-01T09:41:38.190" v="2839" actId="478"/>
          <ac:picMkLst>
            <pc:docMk/>
            <pc:sldMk cId="3393704244" sldId="262"/>
            <ac:picMk id="13" creationId="{971B11F5-9195-4367-ACF3-4FBE5C80267B}"/>
          </ac:picMkLst>
        </pc:picChg>
        <pc:picChg chg="add del mod ord">
          <ac:chgData name="Mintzas, Konstantinos - SEG" userId="8c131287-7383-4bd1-a38f-81a83fd893f4" providerId="ADAL" clId="{0D250578-30A5-42D4-8C88-BF27776B7108}" dt="2023-06-05T12:33:37.965" v="5682" actId="478"/>
          <ac:picMkLst>
            <pc:docMk/>
            <pc:sldMk cId="3393704244" sldId="262"/>
            <ac:picMk id="13" creationId="{CC49761B-7AB0-4C89-8203-E2230E2BBEAC}"/>
          </ac:picMkLst>
        </pc:picChg>
        <pc:picChg chg="add del mod ord">
          <ac:chgData name="Mintzas, Konstantinos - SEG" userId="8c131287-7383-4bd1-a38f-81a83fd893f4" providerId="ADAL" clId="{0D250578-30A5-42D4-8C88-BF27776B7108}" dt="2023-06-01T08:42:49.708" v="2685" actId="478"/>
          <ac:picMkLst>
            <pc:docMk/>
            <pc:sldMk cId="3393704244" sldId="262"/>
            <ac:picMk id="15" creationId="{37F6D335-D2BA-481E-A3E2-207C5D72F909}"/>
          </ac:picMkLst>
        </pc:picChg>
        <pc:picChg chg="add del mod ord">
          <ac:chgData name="Mintzas, Konstantinos - SEG" userId="8c131287-7383-4bd1-a38f-81a83fd893f4" providerId="ADAL" clId="{0D250578-30A5-42D4-8C88-BF27776B7108}" dt="2023-06-01T09:41:38.190" v="2839" actId="478"/>
          <ac:picMkLst>
            <pc:docMk/>
            <pc:sldMk cId="3393704244" sldId="262"/>
            <ac:picMk id="15" creationId="{59E4D348-64BE-4BAF-864F-EC83864130C2}"/>
          </ac:picMkLst>
        </pc:picChg>
        <pc:picChg chg="add mod ord">
          <ac:chgData name="Mintzas, Konstantinos - SEG" userId="8c131287-7383-4bd1-a38f-81a83fd893f4" providerId="ADAL" clId="{0D250578-30A5-42D4-8C88-BF27776B7108}" dt="2023-06-05T12:33:34.732" v="5681" actId="1076"/>
          <ac:picMkLst>
            <pc:docMk/>
            <pc:sldMk cId="3393704244" sldId="262"/>
            <ac:picMk id="15" creationId="{CBF5495A-E2A1-455D-BFFD-FD5553532656}"/>
          </ac:picMkLst>
        </pc:picChg>
        <pc:picChg chg="add mod ord">
          <ac:chgData name="Mintzas, Konstantinos - SEG" userId="8c131287-7383-4bd1-a38f-81a83fd893f4" providerId="ADAL" clId="{0D250578-30A5-42D4-8C88-BF27776B7108}" dt="2023-06-05T12:33:26.274" v="5680" actId="1076"/>
          <ac:picMkLst>
            <pc:docMk/>
            <pc:sldMk cId="3393704244" sldId="262"/>
            <ac:picMk id="17" creationId="{68AF445E-42F0-4383-8E27-E63A767C8D5A}"/>
          </ac:picMkLst>
        </pc:picChg>
        <pc:picChg chg="add del mod ord">
          <ac:chgData name="Mintzas, Konstantinos - SEG" userId="8c131287-7383-4bd1-a38f-81a83fd893f4" providerId="ADAL" clId="{0D250578-30A5-42D4-8C88-BF27776B7108}" dt="2023-06-01T08:42:49.708" v="2685" actId="478"/>
          <ac:picMkLst>
            <pc:docMk/>
            <pc:sldMk cId="3393704244" sldId="262"/>
            <ac:picMk id="17" creationId="{813E87CE-D249-4AFE-BFF2-47AD2D0CA33E}"/>
          </ac:picMkLst>
        </pc:picChg>
        <pc:picChg chg="add del mod ord">
          <ac:chgData name="Mintzas, Konstantinos - SEG" userId="8c131287-7383-4bd1-a38f-81a83fd893f4" providerId="ADAL" clId="{0D250578-30A5-42D4-8C88-BF27776B7108}" dt="2023-06-01T09:41:38.190" v="2839" actId="478"/>
          <ac:picMkLst>
            <pc:docMk/>
            <pc:sldMk cId="3393704244" sldId="262"/>
            <ac:picMk id="17" creationId="{8490B981-0B49-46EE-840E-69753350375F}"/>
          </ac:picMkLst>
        </pc:picChg>
        <pc:picChg chg="add mod ord">
          <ac:chgData name="Mintzas, Konstantinos - SEG" userId="8c131287-7383-4bd1-a38f-81a83fd893f4" providerId="ADAL" clId="{0D250578-30A5-42D4-8C88-BF27776B7108}" dt="2023-06-05T12:33:15.030" v="5679" actId="1076"/>
          <ac:picMkLst>
            <pc:docMk/>
            <pc:sldMk cId="3393704244" sldId="262"/>
            <ac:picMk id="19" creationId="{312E822E-BA89-4836-91CB-C695FF9A0C74}"/>
          </ac:picMkLst>
        </pc:picChg>
        <pc:picChg chg="add del mod ord">
          <ac:chgData name="Mintzas, Konstantinos - SEG" userId="8c131287-7383-4bd1-a38f-81a83fd893f4" providerId="ADAL" clId="{0D250578-30A5-42D4-8C88-BF27776B7108}" dt="2023-06-01T09:58:23.938" v="2849" actId="478"/>
          <ac:picMkLst>
            <pc:docMk/>
            <pc:sldMk cId="3393704244" sldId="262"/>
            <ac:picMk id="19" creationId="{AB917D77-DB9E-4149-BF72-CCE61FA9AE9C}"/>
          </ac:picMkLst>
        </pc:picChg>
        <pc:picChg chg="add del mod ord">
          <ac:chgData name="Mintzas, Konstantinos - SEG" userId="8c131287-7383-4bd1-a38f-81a83fd893f4" providerId="ADAL" clId="{0D250578-30A5-42D4-8C88-BF27776B7108}" dt="2023-06-01T08:42:51.430" v="2686" actId="478"/>
          <ac:picMkLst>
            <pc:docMk/>
            <pc:sldMk cId="3393704244" sldId="262"/>
            <ac:picMk id="19" creationId="{E5E9E01C-4F71-410C-81E8-864F4EEA9FA3}"/>
          </ac:picMkLst>
        </pc:picChg>
        <pc:picChg chg="add del mod">
          <ac:chgData name="Mintzas, Konstantinos - SEG" userId="8c131287-7383-4bd1-a38f-81a83fd893f4" providerId="ADAL" clId="{0D250578-30A5-42D4-8C88-BF27776B7108}" dt="2023-06-05T09:34:36.681" v="3733" actId="478"/>
          <ac:picMkLst>
            <pc:docMk/>
            <pc:sldMk cId="3393704244" sldId="262"/>
            <ac:picMk id="21" creationId="{8A1FE676-F4BF-4FF7-9F05-0349508729FF}"/>
          </ac:picMkLst>
        </pc:picChg>
        <pc:picChg chg="add del mod ord">
          <ac:chgData name="Mintzas, Konstantinos - SEG" userId="8c131287-7383-4bd1-a38f-81a83fd893f4" providerId="ADAL" clId="{0D250578-30A5-42D4-8C88-BF27776B7108}" dt="2023-06-01T09:40:48.714" v="2832" actId="478"/>
          <ac:picMkLst>
            <pc:docMk/>
            <pc:sldMk cId="3393704244" sldId="262"/>
            <ac:picMk id="21" creationId="{9F0167FF-9021-4797-BB7A-11EA9BBCAD97}"/>
          </ac:picMkLst>
        </pc:picChg>
        <pc:picChg chg="add del mod">
          <ac:chgData name="Mintzas, Konstantinos - SEG" userId="8c131287-7383-4bd1-a38f-81a83fd893f4" providerId="ADAL" clId="{0D250578-30A5-42D4-8C88-BF27776B7108}" dt="2023-06-05T09:34:36.681" v="3733" actId="478"/>
          <ac:picMkLst>
            <pc:docMk/>
            <pc:sldMk cId="3393704244" sldId="262"/>
            <ac:picMk id="22" creationId="{25FB32C5-F878-4B7E-90E1-98C26C049ADB}"/>
          </ac:picMkLst>
        </pc:picChg>
        <pc:picChg chg="add del mod ord">
          <ac:chgData name="Mintzas, Konstantinos - SEG" userId="8c131287-7383-4bd1-a38f-81a83fd893f4" providerId="ADAL" clId="{0D250578-30A5-42D4-8C88-BF27776B7108}" dt="2023-06-01T09:58:23.938" v="2849" actId="478"/>
          <ac:picMkLst>
            <pc:docMk/>
            <pc:sldMk cId="3393704244" sldId="262"/>
            <ac:picMk id="22" creationId="{799FCE64-F944-49BA-90A6-2C366B4A1CA8}"/>
          </ac:picMkLst>
        </pc:picChg>
        <pc:picChg chg="add del mod ord">
          <ac:chgData name="Mintzas, Konstantinos - SEG" userId="8c131287-7383-4bd1-a38f-81a83fd893f4" providerId="ADAL" clId="{0D250578-30A5-42D4-8C88-BF27776B7108}" dt="2023-06-01T09:40:48.714" v="2832" actId="478"/>
          <ac:picMkLst>
            <pc:docMk/>
            <pc:sldMk cId="3393704244" sldId="262"/>
            <ac:picMk id="23" creationId="{20A4215C-F4B2-4C4A-8576-B5CEB07CDFD8}"/>
          </ac:picMkLst>
        </pc:picChg>
        <pc:picChg chg="add del mod">
          <ac:chgData name="Mintzas, Konstantinos - SEG" userId="8c131287-7383-4bd1-a38f-81a83fd893f4" providerId="ADAL" clId="{0D250578-30A5-42D4-8C88-BF27776B7108}" dt="2023-06-05T09:34:36.681" v="3733" actId="478"/>
          <ac:picMkLst>
            <pc:docMk/>
            <pc:sldMk cId="3393704244" sldId="262"/>
            <ac:picMk id="23" creationId="{F513CEED-FD78-41B7-B822-8F74B537414E}"/>
          </ac:picMkLst>
        </pc:picChg>
        <pc:picChg chg="add mod ord">
          <ac:chgData name="Mintzas, Konstantinos - SEG" userId="8c131287-7383-4bd1-a38f-81a83fd893f4" providerId="ADAL" clId="{0D250578-30A5-42D4-8C88-BF27776B7108}" dt="2023-06-05T12:34:20.316" v="5690" actId="1076"/>
          <ac:picMkLst>
            <pc:docMk/>
            <pc:sldMk cId="3393704244" sldId="262"/>
            <ac:picMk id="24" creationId="{BEC7AF92-333D-4551-BD49-55A762636E0F}"/>
          </ac:picMkLst>
        </pc:picChg>
        <pc:picChg chg="add del mod ord">
          <ac:chgData name="Mintzas, Konstantinos - SEG" userId="8c131287-7383-4bd1-a38f-81a83fd893f4" providerId="ADAL" clId="{0D250578-30A5-42D4-8C88-BF27776B7108}" dt="2023-06-01T09:40:48.714" v="2832" actId="478"/>
          <ac:picMkLst>
            <pc:docMk/>
            <pc:sldMk cId="3393704244" sldId="262"/>
            <ac:picMk id="25" creationId="{DCF4C8C0-3E13-4BEE-969F-31E3226D2B35}"/>
          </ac:picMkLst>
        </pc:picChg>
        <pc:picChg chg="add mod ord">
          <ac:chgData name="Mintzas, Konstantinos - SEG" userId="8c131287-7383-4bd1-a38f-81a83fd893f4" providerId="ADAL" clId="{0D250578-30A5-42D4-8C88-BF27776B7108}" dt="2023-06-05T12:34:10.176" v="5689" actId="1076"/>
          <ac:picMkLst>
            <pc:docMk/>
            <pc:sldMk cId="3393704244" sldId="262"/>
            <ac:picMk id="26" creationId="{1BD843DB-B11B-4516-B35B-310F09D09C7D}"/>
          </ac:picMkLst>
        </pc:picChg>
        <pc:picChg chg="add del mod ord">
          <ac:chgData name="Mintzas, Konstantinos - SEG" userId="8c131287-7383-4bd1-a38f-81a83fd893f4" providerId="ADAL" clId="{0D250578-30A5-42D4-8C88-BF27776B7108}" dt="2023-06-01T09:58:23.938" v="2849" actId="478"/>
          <ac:picMkLst>
            <pc:docMk/>
            <pc:sldMk cId="3393704244" sldId="262"/>
            <ac:picMk id="26" creationId="{4C833DCB-E307-47BA-90DB-54FB698B7BD7}"/>
          </ac:picMkLst>
        </pc:picChg>
        <pc:picChg chg="add mod ord">
          <ac:chgData name="Mintzas, Konstantinos - SEG" userId="8c131287-7383-4bd1-a38f-81a83fd893f4" providerId="ADAL" clId="{0D250578-30A5-42D4-8C88-BF27776B7108}" dt="2023-06-05T12:34:00.016" v="5688" actId="1076"/>
          <ac:picMkLst>
            <pc:docMk/>
            <pc:sldMk cId="3393704244" sldId="262"/>
            <ac:picMk id="28" creationId="{22D0E0EF-2D20-45C9-B91A-CC0B012A900B}"/>
          </ac:picMkLst>
        </pc:picChg>
        <pc:picChg chg="add del mod ord">
          <ac:chgData name="Mintzas, Konstantinos - SEG" userId="8c131287-7383-4bd1-a38f-81a83fd893f4" providerId="ADAL" clId="{0D250578-30A5-42D4-8C88-BF27776B7108}" dt="2023-06-01T09:58:23.938" v="2849" actId="478"/>
          <ac:picMkLst>
            <pc:docMk/>
            <pc:sldMk cId="3393704244" sldId="262"/>
            <ac:picMk id="28" creationId="{B2A90B84-BA26-4A84-933B-D83B871653C9}"/>
          </ac:picMkLst>
        </pc:picChg>
        <pc:picChg chg="add del mod ord">
          <ac:chgData name="Mintzas, Konstantinos - SEG" userId="8c131287-7383-4bd1-a38f-81a83fd893f4" providerId="ADAL" clId="{0D250578-30A5-42D4-8C88-BF27776B7108}" dt="2023-06-01T09:58:23.938" v="2849" actId="478"/>
          <ac:picMkLst>
            <pc:docMk/>
            <pc:sldMk cId="3393704244" sldId="262"/>
            <ac:picMk id="30" creationId="{7C6D18FB-67A2-4A4F-8950-3406517D5C36}"/>
          </ac:picMkLst>
        </pc:picChg>
        <pc:picChg chg="add mod ord">
          <ac:chgData name="Mintzas, Konstantinos - SEG" userId="8c131287-7383-4bd1-a38f-81a83fd893f4" providerId="ADAL" clId="{0D250578-30A5-42D4-8C88-BF27776B7108}" dt="2023-06-05T12:34:52.680" v="5698" actId="1076"/>
          <ac:picMkLst>
            <pc:docMk/>
            <pc:sldMk cId="3393704244" sldId="262"/>
            <ac:picMk id="30" creationId="{8AD577FA-19D1-45B4-8917-94BD8096FD51}"/>
          </ac:picMkLst>
        </pc:picChg>
        <pc:picChg chg="add mod ord">
          <ac:chgData name="Mintzas, Konstantinos - SEG" userId="8c131287-7383-4bd1-a38f-81a83fd893f4" providerId="ADAL" clId="{0D250578-30A5-42D4-8C88-BF27776B7108}" dt="2023-06-05T12:34:46.765" v="5697" actId="1076"/>
          <ac:picMkLst>
            <pc:docMk/>
            <pc:sldMk cId="3393704244" sldId="262"/>
            <ac:picMk id="32" creationId="{1BCEFC12-CE85-430D-8DDE-F01B30DC1498}"/>
          </ac:picMkLst>
        </pc:picChg>
        <pc:picChg chg="add del mod ord">
          <ac:chgData name="Mintzas, Konstantinos - SEG" userId="8c131287-7383-4bd1-a38f-81a83fd893f4" providerId="ADAL" clId="{0D250578-30A5-42D4-8C88-BF27776B7108}" dt="2023-06-01T09:58:23.938" v="2849" actId="478"/>
          <ac:picMkLst>
            <pc:docMk/>
            <pc:sldMk cId="3393704244" sldId="262"/>
            <ac:picMk id="32" creationId="{A5B400B0-7BFE-402F-B2F4-B2979AA3DC6E}"/>
          </ac:picMkLst>
        </pc:picChg>
        <pc:picChg chg="add del mod ord">
          <ac:chgData name="Mintzas, Konstantinos - SEG" userId="8c131287-7383-4bd1-a38f-81a83fd893f4" providerId="ADAL" clId="{0D250578-30A5-42D4-8C88-BF27776B7108}" dt="2023-06-05T12:32:56.354" v="5674" actId="478"/>
          <ac:picMkLst>
            <pc:docMk/>
            <pc:sldMk cId="3393704244" sldId="262"/>
            <ac:picMk id="34" creationId="{576BABDE-D4A0-4DE3-93C4-C9DEE6385F0B}"/>
          </ac:picMkLst>
        </pc:picChg>
        <pc:picChg chg="add mod ord">
          <ac:chgData name="Mintzas, Konstantinos - SEG" userId="8c131287-7383-4bd1-a38f-81a83fd893f4" providerId="ADAL" clId="{0D250578-30A5-42D4-8C88-BF27776B7108}" dt="2023-06-05T12:34:36.104" v="5696" actId="1076"/>
          <ac:picMkLst>
            <pc:docMk/>
            <pc:sldMk cId="3393704244" sldId="262"/>
            <ac:picMk id="35" creationId="{1944F119-7143-4417-BC40-6D96A51AC312}"/>
          </ac:picMkLst>
        </pc:picChg>
        <pc:picChg chg="add del mod ord">
          <ac:chgData name="Mintzas, Konstantinos - SEG" userId="8c131287-7383-4bd1-a38f-81a83fd893f4" providerId="ADAL" clId="{0D250578-30A5-42D4-8C88-BF27776B7108}" dt="2023-06-05T12:32:56.354" v="5674" actId="478"/>
          <ac:picMkLst>
            <pc:docMk/>
            <pc:sldMk cId="3393704244" sldId="262"/>
            <ac:picMk id="36" creationId="{41F96921-05AE-4D00-B0DA-A04AFE0E1400}"/>
          </ac:picMkLst>
        </pc:picChg>
        <pc:picChg chg="add del mod ord">
          <ac:chgData name="Mintzas, Konstantinos - SEG" userId="8c131287-7383-4bd1-a38f-81a83fd893f4" providerId="ADAL" clId="{0D250578-30A5-42D4-8C88-BF27776B7108}" dt="2023-06-05T12:32:56.354" v="5674" actId="478"/>
          <ac:picMkLst>
            <pc:docMk/>
            <pc:sldMk cId="3393704244" sldId="262"/>
            <ac:picMk id="38" creationId="{FBF096DF-973D-4FD2-8FB8-76D8DAC5710A}"/>
          </ac:picMkLst>
        </pc:picChg>
        <pc:picChg chg="add del mod ord">
          <ac:chgData name="Mintzas, Konstantinos - SEG" userId="8c131287-7383-4bd1-a38f-81a83fd893f4" providerId="ADAL" clId="{0D250578-30A5-42D4-8C88-BF27776B7108}" dt="2023-06-05T12:33:37.965" v="5682" actId="478"/>
          <ac:picMkLst>
            <pc:docMk/>
            <pc:sldMk cId="3393704244" sldId="262"/>
            <ac:picMk id="40" creationId="{95E0F2C3-8A4B-46F3-B072-0E7F88A70152}"/>
          </ac:picMkLst>
        </pc:picChg>
        <pc:picChg chg="add del mod ord">
          <ac:chgData name="Mintzas, Konstantinos - SEG" userId="8c131287-7383-4bd1-a38f-81a83fd893f4" providerId="ADAL" clId="{0D250578-30A5-42D4-8C88-BF27776B7108}" dt="2023-06-05T12:33:37.965" v="5682" actId="478"/>
          <ac:picMkLst>
            <pc:docMk/>
            <pc:sldMk cId="3393704244" sldId="262"/>
            <ac:picMk id="42" creationId="{520A37D8-4434-41EE-9806-2A5AB4D6DCB9}"/>
          </ac:picMkLst>
        </pc:picChg>
        <pc:picChg chg="add del mod ord">
          <ac:chgData name="Mintzas, Konstantinos - SEG" userId="8c131287-7383-4bd1-a38f-81a83fd893f4" providerId="ADAL" clId="{0D250578-30A5-42D4-8C88-BF27776B7108}" dt="2023-06-05T12:12:56.457" v="5654" actId="478"/>
          <ac:picMkLst>
            <pc:docMk/>
            <pc:sldMk cId="3393704244" sldId="262"/>
            <ac:picMk id="44" creationId="{B44D1DA5-D85C-44B6-BF10-932F2E023C7A}"/>
          </ac:picMkLst>
        </pc:picChg>
        <pc:picChg chg="add del mod ord">
          <ac:chgData name="Mintzas, Konstantinos - SEG" userId="8c131287-7383-4bd1-a38f-81a83fd893f4" providerId="ADAL" clId="{0D250578-30A5-42D4-8C88-BF27776B7108}" dt="2023-06-05T12:33:37.965" v="5682" actId="478"/>
          <ac:picMkLst>
            <pc:docMk/>
            <pc:sldMk cId="3393704244" sldId="262"/>
            <ac:picMk id="46" creationId="{690CDE4E-C60F-4396-B664-FC9C97EB86E0}"/>
          </ac:picMkLst>
        </pc:picChg>
        <pc:picChg chg="add del mod ord">
          <ac:chgData name="Mintzas, Konstantinos - SEG" userId="8c131287-7383-4bd1-a38f-81a83fd893f4" providerId="ADAL" clId="{0D250578-30A5-42D4-8C88-BF27776B7108}" dt="2023-06-05T12:33:37.965" v="5682" actId="478"/>
          <ac:picMkLst>
            <pc:docMk/>
            <pc:sldMk cId="3393704244" sldId="262"/>
            <ac:picMk id="48" creationId="{8475F05B-790D-4DF9-9A5A-65EDD14FC374}"/>
          </ac:picMkLst>
        </pc:picChg>
        <pc:picChg chg="add del mod ord">
          <ac:chgData name="Mintzas, Konstantinos - SEG" userId="8c131287-7383-4bd1-a38f-81a83fd893f4" providerId="ADAL" clId="{0D250578-30A5-42D4-8C88-BF27776B7108}" dt="2023-06-05T12:33:37.965" v="5682" actId="478"/>
          <ac:picMkLst>
            <pc:docMk/>
            <pc:sldMk cId="3393704244" sldId="262"/>
            <ac:picMk id="50" creationId="{FD4835B3-139F-4828-AB64-0AB3ED78D753}"/>
          </ac:picMkLst>
        </pc:picChg>
      </pc:sldChg>
      <pc:sldChg chg="new del">
        <pc:chgData name="Mintzas, Konstantinos - SEG" userId="8c131287-7383-4bd1-a38f-81a83fd893f4" providerId="ADAL" clId="{0D250578-30A5-42D4-8C88-BF27776B7108}" dt="2023-06-02T05:30:09.516" v="3537" actId="2696"/>
        <pc:sldMkLst>
          <pc:docMk/>
          <pc:sldMk cId="1249859702" sldId="263"/>
        </pc:sldMkLst>
      </pc:sldChg>
      <pc:sldChg chg="addSp delSp modSp add mod">
        <pc:chgData name="Mintzas, Konstantinos - SEG" userId="8c131287-7383-4bd1-a38f-81a83fd893f4" providerId="ADAL" clId="{0D250578-30A5-42D4-8C88-BF27776B7108}" dt="2023-06-05T11:42:53.318" v="5644" actId="1076"/>
        <pc:sldMkLst>
          <pc:docMk/>
          <pc:sldMk cId="1402241650" sldId="263"/>
        </pc:sldMkLst>
        <pc:spChg chg="mod">
          <ac:chgData name="Mintzas, Konstantinos - SEG" userId="8c131287-7383-4bd1-a38f-81a83fd893f4" providerId="ADAL" clId="{0D250578-30A5-42D4-8C88-BF27776B7108}" dt="2023-06-02T08:55:30.261" v="3674" actId="20577"/>
          <ac:spMkLst>
            <pc:docMk/>
            <pc:sldMk cId="1402241650" sldId="263"/>
            <ac:spMk id="2" creationId="{88AFF230-1DA5-46F7-BBA8-01E209F1227E}"/>
          </ac:spMkLst>
        </pc:spChg>
        <pc:picChg chg="add del mod ord">
          <ac:chgData name="Mintzas, Konstantinos - SEG" userId="8c131287-7383-4bd1-a38f-81a83fd893f4" providerId="ADAL" clId="{0D250578-30A5-42D4-8C88-BF27776B7108}" dt="2023-06-05T11:28:58.825" v="5583" actId="478"/>
          <ac:picMkLst>
            <pc:docMk/>
            <pc:sldMk cId="1402241650" sldId="263"/>
            <ac:picMk id="13" creationId="{BD93FAE0-FC83-46D4-AEA5-C2CAB9782742}"/>
          </ac:picMkLst>
        </pc:picChg>
        <pc:picChg chg="add mod ord">
          <ac:chgData name="Mintzas, Konstantinos - SEG" userId="8c131287-7383-4bd1-a38f-81a83fd893f4" providerId="ADAL" clId="{0D250578-30A5-42D4-8C88-BF27776B7108}" dt="2023-06-05T11:40:27.804" v="5636" actId="1038"/>
          <ac:picMkLst>
            <pc:docMk/>
            <pc:sldMk cId="1402241650" sldId="263"/>
            <ac:picMk id="14" creationId="{B7AF3360-14F1-4E06-B464-F69F5E266580}"/>
          </ac:picMkLst>
        </pc:picChg>
        <pc:picChg chg="add del mod ord">
          <ac:chgData name="Mintzas, Konstantinos - SEG" userId="8c131287-7383-4bd1-a38f-81a83fd893f4" providerId="ADAL" clId="{0D250578-30A5-42D4-8C88-BF27776B7108}" dt="2023-06-05T11:28:58.825" v="5583" actId="478"/>
          <ac:picMkLst>
            <pc:docMk/>
            <pc:sldMk cId="1402241650" sldId="263"/>
            <ac:picMk id="15" creationId="{68CA0BFD-C9A0-4F44-A95C-E773DD233699}"/>
          </ac:picMkLst>
        </pc:picChg>
        <pc:picChg chg="add del mod ord">
          <ac:chgData name="Mintzas, Konstantinos - SEG" userId="8c131287-7383-4bd1-a38f-81a83fd893f4" providerId="ADAL" clId="{0D250578-30A5-42D4-8C88-BF27776B7108}" dt="2023-06-05T11:28:58.825" v="5583" actId="478"/>
          <ac:picMkLst>
            <pc:docMk/>
            <pc:sldMk cId="1402241650" sldId="263"/>
            <ac:picMk id="17" creationId="{1CAC0511-AAF2-4891-B533-46689A3BED01}"/>
          </ac:picMkLst>
        </pc:picChg>
        <pc:picChg chg="add del mod ord">
          <ac:chgData name="Mintzas, Konstantinos - SEG" userId="8c131287-7383-4bd1-a38f-81a83fd893f4" providerId="ADAL" clId="{0D250578-30A5-42D4-8C88-BF27776B7108}" dt="2023-06-05T11:42:23.345" v="5638" actId="478"/>
          <ac:picMkLst>
            <pc:docMk/>
            <pc:sldMk cId="1402241650" sldId="263"/>
            <ac:picMk id="18" creationId="{D072774B-BE67-4DC6-AD77-8E7BFCF1E7E4}"/>
          </ac:picMkLst>
        </pc:picChg>
        <pc:picChg chg="add del mod ord">
          <ac:chgData name="Mintzas, Konstantinos - SEG" userId="8c131287-7383-4bd1-a38f-81a83fd893f4" providerId="ADAL" clId="{0D250578-30A5-42D4-8C88-BF27776B7108}" dt="2023-06-05T11:32:07.847" v="5595" actId="478"/>
          <ac:picMkLst>
            <pc:docMk/>
            <pc:sldMk cId="1402241650" sldId="263"/>
            <ac:picMk id="19" creationId="{98857093-789A-42C0-A470-409CDFA9333D}"/>
          </ac:picMkLst>
        </pc:picChg>
        <pc:picChg chg="add del mod ord">
          <ac:chgData name="Mintzas, Konstantinos - SEG" userId="8c131287-7383-4bd1-a38f-81a83fd893f4" providerId="ADAL" clId="{0D250578-30A5-42D4-8C88-BF27776B7108}" dt="2023-06-05T11:32:07.847" v="5595" actId="478"/>
          <ac:picMkLst>
            <pc:docMk/>
            <pc:sldMk cId="1402241650" sldId="263"/>
            <ac:picMk id="21" creationId="{0A185AED-1E98-4351-B05B-CFD1668FE524}"/>
          </ac:picMkLst>
        </pc:picChg>
        <pc:picChg chg="add mod ord">
          <ac:chgData name="Mintzas, Konstantinos - SEG" userId="8c131287-7383-4bd1-a38f-81a83fd893f4" providerId="ADAL" clId="{0D250578-30A5-42D4-8C88-BF27776B7108}" dt="2023-06-05T11:29:55.177" v="5594" actId="1076"/>
          <ac:picMkLst>
            <pc:docMk/>
            <pc:sldMk cId="1402241650" sldId="263"/>
            <ac:picMk id="22" creationId="{09EDED62-4A66-4576-97CE-3B5A098E9825}"/>
          </ac:picMkLst>
        </pc:picChg>
        <pc:picChg chg="add del mod ord">
          <ac:chgData name="Mintzas, Konstantinos - SEG" userId="8c131287-7383-4bd1-a38f-81a83fd893f4" providerId="ADAL" clId="{0D250578-30A5-42D4-8C88-BF27776B7108}" dt="2023-06-05T11:32:07.847" v="5595" actId="478"/>
          <ac:picMkLst>
            <pc:docMk/>
            <pc:sldMk cId="1402241650" sldId="263"/>
            <ac:picMk id="23" creationId="{BA743780-84F2-45DF-9618-585141006263}"/>
          </ac:picMkLst>
        </pc:picChg>
        <pc:picChg chg="add del mod ord">
          <ac:chgData name="Mintzas, Konstantinos - SEG" userId="8c131287-7383-4bd1-a38f-81a83fd893f4" providerId="ADAL" clId="{0D250578-30A5-42D4-8C88-BF27776B7108}" dt="2023-06-05T11:38:20.897" v="5614" actId="478"/>
          <ac:picMkLst>
            <pc:docMk/>
            <pc:sldMk cId="1402241650" sldId="263"/>
            <ac:picMk id="25" creationId="{7F956362-4159-4720-AFE6-880B4AED03D6}"/>
          </ac:picMkLst>
        </pc:picChg>
        <pc:picChg chg="add mod ord">
          <ac:chgData name="Mintzas, Konstantinos - SEG" userId="8c131287-7383-4bd1-a38f-81a83fd893f4" providerId="ADAL" clId="{0D250578-30A5-42D4-8C88-BF27776B7108}" dt="2023-06-05T11:40:27.804" v="5636" actId="1038"/>
          <ac:picMkLst>
            <pc:docMk/>
            <pc:sldMk cId="1402241650" sldId="263"/>
            <ac:picMk id="26" creationId="{B7D1FF2E-D990-4592-84B5-4AF591B65A48}"/>
          </ac:picMkLst>
        </pc:picChg>
        <pc:picChg chg="add del mod ord">
          <ac:chgData name="Mintzas, Konstantinos - SEG" userId="8c131287-7383-4bd1-a38f-81a83fd893f4" providerId="ADAL" clId="{0D250578-30A5-42D4-8C88-BF27776B7108}" dt="2023-06-05T11:38:20.897" v="5614" actId="478"/>
          <ac:picMkLst>
            <pc:docMk/>
            <pc:sldMk cId="1402241650" sldId="263"/>
            <ac:picMk id="27" creationId="{86C8944C-8720-4ACE-BAB4-FFFEA55CC626}"/>
          </ac:picMkLst>
        </pc:picChg>
        <pc:picChg chg="add del mod ord">
          <ac:chgData name="Mintzas, Konstantinos - SEG" userId="8c131287-7383-4bd1-a38f-81a83fd893f4" providerId="ADAL" clId="{0D250578-30A5-42D4-8C88-BF27776B7108}" dt="2023-06-05T11:38:20.897" v="5614" actId="478"/>
          <ac:picMkLst>
            <pc:docMk/>
            <pc:sldMk cId="1402241650" sldId="263"/>
            <ac:picMk id="29" creationId="{388F3335-9C09-43E8-BD29-5342975B12D5}"/>
          </ac:picMkLst>
        </pc:picChg>
        <pc:picChg chg="add del mod ord">
          <ac:chgData name="Mintzas, Konstantinos - SEG" userId="8c131287-7383-4bd1-a38f-81a83fd893f4" providerId="ADAL" clId="{0D250578-30A5-42D4-8C88-BF27776B7108}" dt="2023-06-05T11:37:04.879" v="5608" actId="478"/>
          <ac:picMkLst>
            <pc:docMk/>
            <pc:sldMk cId="1402241650" sldId="263"/>
            <ac:picMk id="30" creationId="{B609F975-065F-4A6D-89C5-C69404D81837}"/>
          </ac:picMkLst>
        </pc:picChg>
        <pc:picChg chg="add mod ord">
          <ac:chgData name="Mintzas, Konstantinos - SEG" userId="8c131287-7383-4bd1-a38f-81a83fd893f4" providerId="ADAL" clId="{0D250578-30A5-42D4-8C88-BF27776B7108}" dt="2023-06-05T11:32:48.608" v="5607" actId="1076"/>
          <ac:picMkLst>
            <pc:docMk/>
            <pc:sldMk cId="1402241650" sldId="263"/>
            <ac:picMk id="32" creationId="{F9C07CAD-4F07-47DA-9A21-593B8AC3E4CB}"/>
          </ac:picMkLst>
        </pc:picChg>
        <pc:picChg chg="del">
          <ac:chgData name="Mintzas, Konstantinos - SEG" userId="8c131287-7383-4bd1-a38f-81a83fd893f4" providerId="ADAL" clId="{0D250578-30A5-42D4-8C88-BF27776B7108}" dt="2023-06-02T08:55:45.256" v="3675" actId="478"/>
          <ac:picMkLst>
            <pc:docMk/>
            <pc:sldMk cId="1402241650" sldId="263"/>
            <ac:picMk id="34" creationId="{576BABDE-D4A0-4DE3-93C4-C9DEE6385F0B}"/>
          </ac:picMkLst>
        </pc:picChg>
        <pc:picChg chg="add mod ord">
          <ac:chgData name="Mintzas, Konstantinos - SEG" userId="8c131287-7383-4bd1-a38f-81a83fd893f4" providerId="ADAL" clId="{0D250578-30A5-42D4-8C88-BF27776B7108}" dt="2023-06-05T11:37:25.361" v="5613" actId="1076"/>
          <ac:picMkLst>
            <pc:docMk/>
            <pc:sldMk cId="1402241650" sldId="263"/>
            <ac:picMk id="34" creationId="{769C24D2-B2BD-4873-A1FF-2D443B6CF1F2}"/>
          </ac:picMkLst>
        </pc:picChg>
        <pc:picChg chg="del">
          <ac:chgData name="Mintzas, Konstantinos - SEG" userId="8c131287-7383-4bd1-a38f-81a83fd893f4" providerId="ADAL" clId="{0D250578-30A5-42D4-8C88-BF27776B7108}" dt="2023-06-02T08:55:45.256" v="3675" actId="478"/>
          <ac:picMkLst>
            <pc:docMk/>
            <pc:sldMk cId="1402241650" sldId="263"/>
            <ac:picMk id="36" creationId="{41F96921-05AE-4D00-B0DA-A04AFE0E1400}"/>
          </ac:picMkLst>
        </pc:picChg>
        <pc:picChg chg="add mod ord">
          <ac:chgData name="Mintzas, Konstantinos - SEG" userId="8c131287-7383-4bd1-a38f-81a83fd893f4" providerId="ADAL" clId="{0D250578-30A5-42D4-8C88-BF27776B7108}" dt="2023-06-05T11:40:27.804" v="5636" actId="1038"/>
          <ac:picMkLst>
            <pc:docMk/>
            <pc:sldMk cId="1402241650" sldId="263"/>
            <ac:picMk id="36" creationId="{B0103127-5A94-4A4E-B5F1-5218B6EE0BB2}"/>
          </ac:picMkLst>
        </pc:picChg>
        <pc:picChg chg="add del mod ord">
          <ac:chgData name="Mintzas, Konstantinos - SEG" userId="8c131287-7383-4bd1-a38f-81a83fd893f4" providerId="ADAL" clId="{0D250578-30A5-42D4-8C88-BF27776B7108}" dt="2023-06-05T11:39:03.983" v="5621" actId="478"/>
          <ac:picMkLst>
            <pc:docMk/>
            <pc:sldMk cId="1402241650" sldId="263"/>
            <ac:picMk id="38" creationId="{19F9A0C5-5A4F-4BBE-B403-A6B86480181B}"/>
          </ac:picMkLst>
        </pc:picChg>
        <pc:picChg chg="del">
          <ac:chgData name="Mintzas, Konstantinos - SEG" userId="8c131287-7383-4bd1-a38f-81a83fd893f4" providerId="ADAL" clId="{0D250578-30A5-42D4-8C88-BF27776B7108}" dt="2023-06-02T08:55:45.256" v="3675" actId="478"/>
          <ac:picMkLst>
            <pc:docMk/>
            <pc:sldMk cId="1402241650" sldId="263"/>
            <ac:picMk id="38" creationId="{FBF096DF-973D-4FD2-8FB8-76D8DAC5710A}"/>
          </ac:picMkLst>
        </pc:picChg>
        <pc:picChg chg="add del mod ord">
          <ac:chgData name="Mintzas, Konstantinos - SEG" userId="8c131287-7383-4bd1-a38f-81a83fd893f4" providerId="ADAL" clId="{0D250578-30A5-42D4-8C88-BF27776B7108}" dt="2023-06-05T11:39:03.983" v="5621" actId="478"/>
          <ac:picMkLst>
            <pc:docMk/>
            <pc:sldMk cId="1402241650" sldId="263"/>
            <ac:picMk id="40" creationId="{88ECD38D-707E-4C3E-9C10-D84C652A82AB}"/>
          </ac:picMkLst>
        </pc:picChg>
        <pc:picChg chg="del">
          <ac:chgData name="Mintzas, Konstantinos - SEG" userId="8c131287-7383-4bd1-a38f-81a83fd893f4" providerId="ADAL" clId="{0D250578-30A5-42D4-8C88-BF27776B7108}" dt="2023-06-02T08:55:45.256" v="3675" actId="478"/>
          <ac:picMkLst>
            <pc:docMk/>
            <pc:sldMk cId="1402241650" sldId="263"/>
            <ac:picMk id="40" creationId="{95E0F2C3-8A4B-46F3-B072-0E7F88A70152}"/>
          </ac:picMkLst>
        </pc:picChg>
        <pc:picChg chg="del">
          <ac:chgData name="Mintzas, Konstantinos - SEG" userId="8c131287-7383-4bd1-a38f-81a83fd893f4" providerId="ADAL" clId="{0D250578-30A5-42D4-8C88-BF27776B7108}" dt="2023-06-02T08:55:45.256" v="3675" actId="478"/>
          <ac:picMkLst>
            <pc:docMk/>
            <pc:sldMk cId="1402241650" sldId="263"/>
            <ac:picMk id="42" creationId="{520A37D8-4434-41EE-9806-2A5AB4D6DCB9}"/>
          </ac:picMkLst>
        </pc:picChg>
        <pc:picChg chg="add mod ord">
          <ac:chgData name="Mintzas, Konstantinos - SEG" userId="8c131287-7383-4bd1-a38f-81a83fd893f4" providerId="ADAL" clId="{0D250578-30A5-42D4-8C88-BF27776B7108}" dt="2023-06-05T11:40:08.021" v="5628" actId="555"/>
          <ac:picMkLst>
            <pc:docMk/>
            <pc:sldMk cId="1402241650" sldId="263"/>
            <ac:picMk id="42" creationId="{FBA2CB3E-C49F-4DF8-873E-FF12CC009BA2}"/>
          </ac:picMkLst>
        </pc:picChg>
        <pc:picChg chg="del">
          <ac:chgData name="Mintzas, Konstantinos - SEG" userId="8c131287-7383-4bd1-a38f-81a83fd893f4" providerId="ADAL" clId="{0D250578-30A5-42D4-8C88-BF27776B7108}" dt="2023-06-02T08:55:45.256" v="3675" actId="478"/>
          <ac:picMkLst>
            <pc:docMk/>
            <pc:sldMk cId="1402241650" sldId="263"/>
            <ac:picMk id="44" creationId="{B44D1DA5-D85C-44B6-BF10-932F2E023C7A}"/>
          </ac:picMkLst>
        </pc:picChg>
        <pc:picChg chg="add del mod ord">
          <ac:chgData name="Mintzas, Konstantinos - SEG" userId="8c131287-7383-4bd1-a38f-81a83fd893f4" providerId="ADAL" clId="{0D250578-30A5-42D4-8C88-BF27776B7108}" dt="2023-06-05T11:41:40.653" v="5637" actId="478"/>
          <ac:picMkLst>
            <pc:docMk/>
            <pc:sldMk cId="1402241650" sldId="263"/>
            <ac:picMk id="44" creationId="{CCA85118-E8B1-4016-81ED-2F875A0D9940}"/>
          </ac:picMkLst>
        </pc:picChg>
        <pc:picChg chg="del">
          <ac:chgData name="Mintzas, Konstantinos - SEG" userId="8c131287-7383-4bd1-a38f-81a83fd893f4" providerId="ADAL" clId="{0D250578-30A5-42D4-8C88-BF27776B7108}" dt="2023-06-02T08:55:45.256" v="3675" actId="478"/>
          <ac:picMkLst>
            <pc:docMk/>
            <pc:sldMk cId="1402241650" sldId="263"/>
            <ac:picMk id="46" creationId="{690CDE4E-C60F-4396-B664-FC9C97EB86E0}"/>
          </ac:picMkLst>
        </pc:picChg>
        <pc:picChg chg="add mod ord">
          <ac:chgData name="Mintzas, Konstantinos - SEG" userId="8c131287-7383-4bd1-a38f-81a83fd893f4" providerId="ADAL" clId="{0D250578-30A5-42D4-8C88-BF27776B7108}" dt="2023-06-05T11:42:53.318" v="5644" actId="1076"/>
          <ac:picMkLst>
            <pc:docMk/>
            <pc:sldMk cId="1402241650" sldId="263"/>
            <ac:picMk id="46" creationId="{7DA82CF3-200E-4126-A629-4C4FADE59905}"/>
          </ac:picMkLst>
        </pc:picChg>
        <pc:picChg chg="del">
          <ac:chgData name="Mintzas, Konstantinos - SEG" userId="8c131287-7383-4bd1-a38f-81a83fd893f4" providerId="ADAL" clId="{0D250578-30A5-42D4-8C88-BF27776B7108}" dt="2023-06-02T08:55:45.256" v="3675" actId="478"/>
          <ac:picMkLst>
            <pc:docMk/>
            <pc:sldMk cId="1402241650" sldId="263"/>
            <ac:picMk id="48" creationId="{8475F05B-790D-4DF9-9A5A-65EDD14FC374}"/>
          </ac:picMkLst>
        </pc:picChg>
        <pc:picChg chg="add mod ord">
          <ac:chgData name="Mintzas, Konstantinos - SEG" userId="8c131287-7383-4bd1-a38f-81a83fd893f4" providerId="ADAL" clId="{0D250578-30A5-42D4-8C88-BF27776B7108}" dt="2023-06-05T11:42:42.609" v="5643" actId="1076"/>
          <ac:picMkLst>
            <pc:docMk/>
            <pc:sldMk cId="1402241650" sldId="263"/>
            <ac:picMk id="48" creationId="{B387AE59-BF84-4105-9EC5-F5A9CB2EF46E}"/>
          </ac:picMkLst>
        </pc:picChg>
        <pc:picChg chg="del">
          <ac:chgData name="Mintzas, Konstantinos - SEG" userId="8c131287-7383-4bd1-a38f-81a83fd893f4" providerId="ADAL" clId="{0D250578-30A5-42D4-8C88-BF27776B7108}" dt="2023-06-02T08:55:45.256" v="3675" actId="478"/>
          <ac:picMkLst>
            <pc:docMk/>
            <pc:sldMk cId="1402241650" sldId="263"/>
            <ac:picMk id="50" creationId="{FD4835B3-139F-4828-AB64-0AB3ED78D753}"/>
          </ac:picMkLst>
        </pc:picChg>
      </pc:sldChg>
      <pc:sldChg chg="addSp modSp new mod modShow">
        <pc:chgData name="Mintzas, Konstantinos - SEG" userId="8c131287-7383-4bd1-a38f-81a83fd893f4" providerId="ADAL" clId="{0D250578-30A5-42D4-8C88-BF27776B7108}" dt="2023-06-05T11:16:40.097" v="5272" actId="729"/>
        <pc:sldMkLst>
          <pc:docMk/>
          <pc:sldMk cId="2171268508" sldId="264"/>
        </pc:sldMkLst>
        <pc:spChg chg="add mod">
          <ac:chgData name="Mintzas, Konstantinos - SEG" userId="8c131287-7383-4bd1-a38f-81a83fd893f4" providerId="ADAL" clId="{0D250578-30A5-42D4-8C88-BF27776B7108}" dt="2023-06-05T10:40:34.359" v="3856" actId="20577"/>
          <ac:spMkLst>
            <pc:docMk/>
            <pc:sldMk cId="2171268508" sldId="264"/>
            <ac:spMk id="3" creationId="{64D7E8E6-89A6-4083-828B-362BB2400CC4}"/>
          </ac:spMkLst>
        </pc:spChg>
        <pc:graphicFrameChg chg="add mod modGraphic">
          <ac:chgData name="Mintzas, Konstantinos - SEG" userId="8c131287-7383-4bd1-a38f-81a83fd893f4" providerId="ADAL" clId="{0D250578-30A5-42D4-8C88-BF27776B7108}" dt="2023-06-05T10:56:11.380" v="4558" actId="20577"/>
          <ac:graphicFrameMkLst>
            <pc:docMk/>
            <pc:sldMk cId="2171268508" sldId="264"/>
            <ac:graphicFrameMk id="2" creationId="{663FE9AD-53C3-432F-AED4-D5677A3816AC}"/>
          </ac:graphicFrameMkLst>
        </pc:graphicFrameChg>
      </pc:sldChg>
      <pc:sldChg chg="new del">
        <pc:chgData name="Mintzas, Konstantinos - SEG" userId="8c131287-7383-4bd1-a38f-81a83fd893f4" providerId="ADAL" clId="{0D250578-30A5-42D4-8C88-BF27776B7108}" dt="2023-06-02T05:30:51.224" v="3538" actId="47"/>
        <pc:sldMkLst>
          <pc:docMk/>
          <pc:sldMk cId="2936271515" sldId="264"/>
        </pc:sldMkLst>
      </pc:sldChg>
      <pc:sldChg chg="modSp add mod modShow">
        <pc:chgData name="Mintzas, Konstantinos - SEG" userId="8c131287-7383-4bd1-a38f-81a83fd893f4" providerId="ADAL" clId="{0D250578-30A5-42D4-8C88-BF27776B7108}" dt="2023-06-05T11:16:40.097" v="5272" actId="729"/>
        <pc:sldMkLst>
          <pc:docMk/>
          <pc:sldMk cId="1911772757" sldId="265"/>
        </pc:sldMkLst>
        <pc:spChg chg="mod">
          <ac:chgData name="Mintzas, Konstantinos - SEG" userId="8c131287-7383-4bd1-a38f-81a83fd893f4" providerId="ADAL" clId="{0D250578-30A5-42D4-8C88-BF27776B7108}" dt="2023-06-05T11:02:14.522" v="4927" actId="20577"/>
          <ac:spMkLst>
            <pc:docMk/>
            <pc:sldMk cId="1911772757" sldId="265"/>
            <ac:spMk id="3" creationId="{64D7E8E6-89A6-4083-828B-362BB2400CC4}"/>
          </ac:spMkLst>
        </pc:spChg>
        <pc:graphicFrameChg chg="mod modGraphic">
          <ac:chgData name="Mintzas, Konstantinos - SEG" userId="8c131287-7383-4bd1-a38f-81a83fd893f4" providerId="ADAL" clId="{0D250578-30A5-42D4-8C88-BF27776B7108}" dt="2023-06-05T11:02:05.892" v="4925" actId="20577"/>
          <ac:graphicFrameMkLst>
            <pc:docMk/>
            <pc:sldMk cId="1911772757" sldId="265"/>
            <ac:graphicFrameMk id="2" creationId="{663FE9AD-53C3-432F-AED4-D5677A3816AC}"/>
          </ac:graphicFrameMkLst>
        </pc:graphicFrameChg>
      </pc:sldChg>
      <pc:sldChg chg="addSp modSp new mod ord modShow">
        <pc:chgData name="Mintzas, Konstantinos - SEG" userId="8c131287-7383-4bd1-a38f-81a83fd893f4" providerId="ADAL" clId="{0D250578-30A5-42D4-8C88-BF27776B7108}" dt="2023-06-05T11:14:08.133" v="5199"/>
        <pc:sldMkLst>
          <pc:docMk/>
          <pc:sldMk cId="713077976" sldId="266"/>
        </pc:sldMkLst>
        <pc:spChg chg="add mod">
          <ac:chgData name="Mintzas, Konstantinos - SEG" userId="8c131287-7383-4bd1-a38f-81a83fd893f4" providerId="ADAL" clId="{0D250578-30A5-42D4-8C88-BF27776B7108}" dt="2023-06-05T11:02:46.551" v="4932"/>
          <ac:spMkLst>
            <pc:docMk/>
            <pc:sldMk cId="713077976" sldId="266"/>
            <ac:spMk id="3" creationId="{EB7956DC-B687-4725-BE1F-202CB9CC3B5B}"/>
          </ac:spMkLst>
        </pc:spChg>
        <pc:spChg chg="add mod">
          <ac:chgData name="Mintzas, Konstantinos - SEG" userId="8c131287-7383-4bd1-a38f-81a83fd893f4" providerId="ADAL" clId="{0D250578-30A5-42D4-8C88-BF27776B7108}" dt="2023-06-05T11:14:08.133" v="5199"/>
          <ac:spMkLst>
            <pc:docMk/>
            <pc:sldMk cId="713077976" sldId="266"/>
            <ac:spMk id="4" creationId="{3DA837D0-30A1-4682-A355-B8BC8AF8A5F2}"/>
          </ac:spMkLst>
        </pc:spChg>
        <pc:graphicFrameChg chg="add mod">
          <ac:chgData name="Mintzas, Konstantinos - SEG" userId="8c131287-7383-4bd1-a38f-81a83fd893f4" providerId="ADAL" clId="{0D250578-30A5-42D4-8C88-BF27776B7108}" dt="2023-06-05T11:02:46.551" v="4932"/>
          <ac:graphicFrameMkLst>
            <pc:docMk/>
            <pc:sldMk cId="713077976" sldId="266"/>
            <ac:graphicFrameMk id="2" creationId="{1104E638-1789-493E-9937-CE30539E5558}"/>
          </ac:graphicFrameMkLst>
        </pc:graphicFrameChg>
        <pc:graphicFrameChg chg="add mod">
          <ac:chgData name="Mintzas, Konstantinos - SEG" userId="8c131287-7383-4bd1-a38f-81a83fd893f4" providerId="ADAL" clId="{0D250578-30A5-42D4-8C88-BF27776B7108}" dt="2023-06-05T11:14:08.133" v="5199"/>
          <ac:graphicFrameMkLst>
            <pc:docMk/>
            <pc:sldMk cId="713077976" sldId="266"/>
            <ac:graphicFrameMk id="5" creationId="{581A6203-D9DF-4356-B8C8-EE2D9493D958}"/>
          </ac:graphicFrameMkLst>
        </pc:graphicFrameChg>
      </pc:sldChg>
      <pc:sldChg chg="addSp delSp modSp add mod ord modShow">
        <pc:chgData name="Mintzas, Konstantinos - SEG" userId="8c131287-7383-4bd1-a38f-81a83fd893f4" providerId="ADAL" clId="{0D250578-30A5-42D4-8C88-BF27776B7108}" dt="2023-06-26T09:03:21.751" v="6587" actId="790"/>
        <pc:sldMkLst>
          <pc:docMk/>
          <pc:sldMk cId="2737034867" sldId="267"/>
        </pc:sldMkLst>
        <pc:spChg chg="del">
          <ac:chgData name="Mintzas, Konstantinos - SEG" userId="8c131287-7383-4bd1-a38f-81a83fd893f4" providerId="ADAL" clId="{0D250578-30A5-42D4-8C88-BF27776B7108}" dt="2023-06-05T11:10:20.098" v="5133" actId="478"/>
          <ac:spMkLst>
            <pc:docMk/>
            <pc:sldMk cId="2737034867" sldId="267"/>
            <ac:spMk id="3" creationId="{64D7E8E6-89A6-4083-828B-362BB2400CC4}"/>
          </ac:spMkLst>
        </pc:spChg>
        <pc:spChg chg="add mod">
          <ac:chgData name="Mintzas, Konstantinos - SEG" userId="8c131287-7383-4bd1-a38f-81a83fd893f4" providerId="ADAL" clId="{0D250578-30A5-42D4-8C88-BF27776B7108}" dt="2023-06-05T11:10:24.576" v="5135" actId="1076"/>
          <ac:spMkLst>
            <pc:docMk/>
            <pc:sldMk cId="2737034867" sldId="267"/>
            <ac:spMk id="4" creationId="{D3B59748-3143-4059-9D6A-34D2031E438A}"/>
          </ac:spMkLst>
        </pc:spChg>
        <pc:graphicFrameChg chg="mod modGraphic">
          <ac:chgData name="Mintzas, Konstantinos - SEG" userId="8c131287-7383-4bd1-a38f-81a83fd893f4" providerId="ADAL" clId="{0D250578-30A5-42D4-8C88-BF27776B7108}" dt="2023-06-26T09:03:21.751" v="6587" actId="790"/>
          <ac:graphicFrameMkLst>
            <pc:docMk/>
            <pc:sldMk cId="2737034867" sldId="267"/>
            <ac:graphicFrameMk id="2" creationId="{663FE9AD-53C3-432F-AED4-D5677A3816AC}"/>
          </ac:graphicFrameMkLst>
        </pc:graphicFrameChg>
      </pc:sldChg>
      <pc:sldChg chg="addSp modSp new mod">
        <pc:chgData name="Mintzas, Konstantinos - SEG" userId="8c131287-7383-4bd1-a38f-81a83fd893f4" providerId="ADAL" clId="{0D250578-30A5-42D4-8C88-BF27776B7108}" dt="2023-06-05T12:25:39.997" v="5673" actId="1076"/>
        <pc:sldMkLst>
          <pc:docMk/>
          <pc:sldMk cId="300474881" sldId="268"/>
        </pc:sldMkLst>
        <pc:spChg chg="add mod">
          <ac:chgData name="Mintzas, Konstantinos - SEG" userId="8c131287-7383-4bd1-a38f-81a83fd893f4" providerId="ADAL" clId="{0D250578-30A5-42D4-8C88-BF27776B7108}" dt="2023-06-05T11:21:40.422" v="5555" actId="20577"/>
          <ac:spMkLst>
            <pc:docMk/>
            <pc:sldMk cId="300474881" sldId="268"/>
            <ac:spMk id="2" creationId="{3AFC5EFF-5D9B-4DE4-96B7-1ED588E024FD}"/>
          </ac:spMkLst>
        </pc:spChg>
        <pc:spChg chg="add mod">
          <ac:chgData name="Mintzas, Konstantinos - SEG" userId="8c131287-7383-4bd1-a38f-81a83fd893f4" providerId="ADAL" clId="{0D250578-30A5-42D4-8C88-BF27776B7108}" dt="2023-06-05T11:22:36.218" v="5581"/>
          <ac:spMkLst>
            <pc:docMk/>
            <pc:sldMk cId="300474881" sldId="268"/>
            <ac:spMk id="3" creationId="{39934577-61FD-4907-8052-18718F0DDF2F}"/>
          </ac:spMkLst>
        </pc:spChg>
        <pc:spChg chg="add mod">
          <ac:chgData name="Mintzas, Konstantinos - SEG" userId="8c131287-7383-4bd1-a38f-81a83fd893f4" providerId="ADAL" clId="{0D250578-30A5-42D4-8C88-BF27776B7108}" dt="2023-06-05T11:22:36.218" v="5581"/>
          <ac:spMkLst>
            <pc:docMk/>
            <pc:sldMk cId="300474881" sldId="268"/>
            <ac:spMk id="4" creationId="{B2345377-3A74-4863-A89D-95212A3A06FA}"/>
          </ac:spMkLst>
        </pc:spChg>
        <pc:spChg chg="add mod">
          <ac:chgData name="Mintzas, Konstantinos - SEG" userId="8c131287-7383-4bd1-a38f-81a83fd893f4" providerId="ADAL" clId="{0D250578-30A5-42D4-8C88-BF27776B7108}" dt="2023-06-05T11:22:36.218" v="5581"/>
          <ac:spMkLst>
            <pc:docMk/>
            <pc:sldMk cId="300474881" sldId="268"/>
            <ac:spMk id="5" creationId="{90868D6F-AF55-4CC0-B1A2-C3BF152700C9}"/>
          </ac:spMkLst>
        </pc:spChg>
        <pc:spChg chg="add mod">
          <ac:chgData name="Mintzas, Konstantinos - SEG" userId="8c131287-7383-4bd1-a38f-81a83fd893f4" providerId="ADAL" clId="{0D250578-30A5-42D4-8C88-BF27776B7108}" dt="2023-06-05T11:22:36.218" v="5581"/>
          <ac:spMkLst>
            <pc:docMk/>
            <pc:sldMk cId="300474881" sldId="268"/>
            <ac:spMk id="6" creationId="{59D2631E-4E5C-46C2-BD93-17520AD3F7F4}"/>
          </ac:spMkLst>
        </pc:spChg>
        <pc:spChg chg="add mod">
          <ac:chgData name="Mintzas, Konstantinos - SEG" userId="8c131287-7383-4bd1-a38f-81a83fd893f4" providerId="ADAL" clId="{0D250578-30A5-42D4-8C88-BF27776B7108}" dt="2023-06-05T11:22:36.218" v="5581"/>
          <ac:spMkLst>
            <pc:docMk/>
            <pc:sldMk cId="300474881" sldId="268"/>
            <ac:spMk id="7" creationId="{BBDDB6AB-669C-4331-9AB9-221785531375}"/>
          </ac:spMkLst>
        </pc:spChg>
        <pc:spChg chg="add mod">
          <ac:chgData name="Mintzas, Konstantinos - SEG" userId="8c131287-7383-4bd1-a38f-81a83fd893f4" providerId="ADAL" clId="{0D250578-30A5-42D4-8C88-BF27776B7108}" dt="2023-06-05T11:22:36.218" v="5581"/>
          <ac:spMkLst>
            <pc:docMk/>
            <pc:sldMk cId="300474881" sldId="268"/>
            <ac:spMk id="8" creationId="{8105E055-38E7-40B1-AA99-0C5533540BB1}"/>
          </ac:spMkLst>
        </pc:spChg>
        <pc:spChg chg="add mod">
          <ac:chgData name="Mintzas, Konstantinos - SEG" userId="8c131287-7383-4bd1-a38f-81a83fd893f4" providerId="ADAL" clId="{0D250578-30A5-42D4-8C88-BF27776B7108}" dt="2023-06-05T11:22:36.218" v="5581"/>
          <ac:spMkLst>
            <pc:docMk/>
            <pc:sldMk cId="300474881" sldId="268"/>
            <ac:spMk id="9" creationId="{51FAB07E-B5AF-4E56-875E-85654A130D81}"/>
          </ac:spMkLst>
        </pc:spChg>
        <pc:spChg chg="add mod">
          <ac:chgData name="Mintzas, Konstantinos - SEG" userId="8c131287-7383-4bd1-a38f-81a83fd893f4" providerId="ADAL" clId="{0D250578-30A5-42D4-8C88-BF27776B7108}" dt="2023-06-05T11:22:36.218" v="5581"/>
          <ac:spMkLst>
            <pc:docMk/>
            <pc:sldMk cId="300474881" sldId="268"/>
            <ac:spMk id="10" creationId="{EA8C8549-FE31-4B37-9AD3-FADEF383DA01}"/>
          </ac:spMkLst>
        </pc:spChg>
        <pc:spChg chg="add mod">
          <ac:chgData name="Mintzas, Konstantinos - SEG" userId="8c131287-7383-4bd1-a38f-81a83fd893f4" providerId="ADAL" clId="{0D250578-30A5-42D4-8C88-BF27776B7108}" dt="2023-06-05T11:22:36.218" v="5581"/>
          <ac:spMkLst>
            <pc:docMk/>
            <pc:sldMk cId="300474881" sldId="268"/>
            <ac:spMk id="11" creationId="{213792BC-D7EA-455E-9C31-97C734869F37}"/>
          </ac:spMkLst>
        </pc:spChg>
        <pc:picChg chg="add mod ord">
          <ac:chgData name="Mintzas, Konstantinos - SEG" userId="8c131287-7383-4bd1-a38f-81a83fd893f4" providerId="ADAL" clId="{0D250578-30A5-42D4-8C88-BF27776B7108}" dt="2023-06-05T12:04:54.211" v="5651" actId="1076"/>
          <ac:picMkLst>
            <pc:docMk/>
            <pc:sldMk cId="300474881" sldId="268"/>
            <ac:picMk id="13" creationId="{55C7EB78-B53C-4EE7-ACE2-47AAF86B1FA3}"/>
          </ac:picMkLst>
        </pc:picChg>
        <pc:picChg chg="add mod ord">
          <ac:chgData name="Mintzas, Konstantinos - SEG" userId="8c131287-7383-4bd1-a38f-81a83fd893f4" providerId="ADAL" clId="{0D250578-30A5-42D4-8C88-BF27776B7108}" dt="2023-06-05T12:04:59.894" v="5652" actId="1076"/>
          <ac:picMkLst>
            <pc:docMk/>
            <pc:sldMk cId="300474881" sldId="268"/>
            <ac:picMk id="15" creationId="{A9A49A53-E2B8-4969-A00C-F82E09D16D13}"/>
          </ac:picMkLst>
        </pc:picChg>
        <pc:picChg chg="add mod ord">
          <ac:chgData name="Mintzas, Konstantinos - SEG" userId="8c131287-7383-4bd1-a38f-81a83fd893f4" providerId="ADAL" clId="{0D250578-30A5-42D4-8C88-BF27776B7108}" dt="2023-06-05T12:05:02.889" v="5653" actId="1076"/>
          <ac:picMkLst>
            <pc:docMk/>
            <pc:sldMk cId="300474881" sldId="268"/>
            <ac:picMk id="17" creationId="{0BBCF95F-EA5C-40E4-9C32-3ED60598A523}"/>
          </ac:picMkLst>
        </pc:picChg>
        <pc:picChg chg="add mod ord">
          <ac:chgData name="Mintzas, Konstantinos - SEG" userId="8c131287-7383-4bd1-a38f-81a83fd893f4" providerId="ADAL" clId="{0D250578-30A5-42D4-8C88-BF27776B7108}" dt="2023-06-05T12:14:34.511" v="5666" actId="1076"/>
          <ac:picMkLst>
            <pc:docMk/>
            <pc:sldMk cId="300474881" sldId="268"/>
            <ac:picMk id="19" creationId="{CD3140A4-875B-481C-8CC0-B9708E4DC538}"/>
          </ac:picMkLst>
        </pc:picChg>
        <pc:picChg chg="add mod ord">
          <ac:chgData name="Mintzas, Konstantinos - SEG" userId="8c131287-7383-4bd1-a38f-81a83fd893f4" providerId="ADAL" clId="{0D250578-30A5-42D4-8C88-BF27776B7108}" dt="2023-06-05T12:14:30.053" v="5665" actId="1076"/>
          <ac:picMkLst>
            <pc:docMk/>
            <pc:sldMk cId="300474881" sldId="268"/>
            <ac:picMk id="21" creationId="{3D854F47-8F04-460D-BB00-35E31BACF716}"/>
          </ac:picMkLst>
        </pc:picChg>
        <pc:picChg chg="add mod ord">
          <ac:chgData name="Mintzas, Konstantinos - SEG" userId="8c131287-7383-4bd1-a38f-81a83fd893f4" providerId="ADAL" clId="{0D250578-30A5-42D4-8C88-BF27776B7108}" dt="2023-06-05T12:14:25.441" v="5664" actId="1076"/>
          <ac:picMkLst>
            <pc:docMk/>
            <pc:sldMk cId="300474881" sldId="268"/>
            <ac:picMk id="23" creationId="{FB7C6382-D6B9-4123-B585-F6E973169635}"/>
          </ac:picMkLst>
        </pc:picChg>
        <pc:picChg chg="add mod ord">
          <ac:chgData name="Mintzas, Konstantinos - SEG" userId="8c131287-7383-4bd1-a38f-81a83fd893f4" providerId="ADAL" clId="{0D250578-30A5-42D4-8C88-BF27776B7108}" dt="2023-06-05T12:25:39.997" v="5673" actId="1076"/>
          <ac:picMkLst>
            <pc:docMk/>
            <pc:sldMk cId="300474881" sldId="268"/>
            <ac:picMk id="25" creationId="{7821C005-E153-4147-8894-5F63BBBF1310}"/>
          </ac:picMkLst>
        </pc:picChg>
        <pc:picChg chg="add mod ord">
          <ac:chgData name="Mintzas, Konstantinos - SEG" userId="8c131287-7383-4bd1-a38f-81a83fd893f4" providerId="ADAL" clId="{0D250578-30A5-42D4-8C88-BF27776B7108}" dt="2023-06-05T12:25:34.367" v="5672" actId="1076"/>
          <ac:picMkLst>
            <pc:docMk/>
            <pc:sldMk cId="300474881" sldId="268"/>
            <ac:picMk id="27" creationId="{0FF1F836-575B-4BBE-ACD7-3E8CFC1E9E2A}"/>
          </ac:picMkLst>
        </pc:picChg>
        <pc:picChg chg="add mod ord">
          <ac:chgData name="Mintzas, Konstantinos - SEG" userId="8c131287-7383-4bd1-a38f-81a83fd893f4" providerId="ADAL" clId="{0D250578-30A5-42D4-8C88-BF27776B7108}" dt="2023-06-05T12:25:29.697" v="5671" actId="1076"/>
          <ac:picMkLst>
            <pc:docMk/>
            <pc:sldMk cId="300474881" sldId="268"/>
            <ac:picMk id="29" creationId="{C6BF826E-9790-4F27-89F6-C4A0B04783D8}"/>
          </ac:picMkLst>
        </pc:picChg>
      </pc:sldChg>
      <pc:sldChg chg="addSp delSp modSp add mod">
        <pc:chgData name="Mintzas, Konstantinos - SEG" userId="8c131287-7383-4bd1-a38f-81a83fd893f4" providerId="ADAL" clId="{0D250578-30A5-42D4-8C88-BF27776B7108}" dt="2023-06-07T08:13:34.445" v="6137" actId="20577"/>
        <pc:sldMkLst>
          <pc:docMk/>
          <pc:sldMk cId="3678178586" sldId="269"/>
        </pc:sldMkLst>
        <pc:spChg chg="mod">
          <ac:chgData name="Mintzas, Konstantinos - SEG" userId="8c131287-7383-4bd1-a38f-81a83fd893f4" providerId="ADAL" clId="{0D250578-30A5-42D4-8C88-BF27776B7108}" dt="2023-06-07T08:13:34.445" v="6137" actId="20577"/>
          <ac:spMkLst>
            <pc:docMk/>
            <pc:sldMk cId="3678178586" sldId="269"/>
            <ac:spMk id="2" creationId="{88AFF230-1DA5-46F7-BBA8-01E209F1227E}"/>
          </ac:spMkLst>
        </pc:spChg>
        <pc:picChg chg="add mod ord">
          <ac:chgData name="Mintzas, Konstantinos - SEG" userId="8c131287-7383-4bd1-a38f-81a83fd893f4" providerId="ADAL" clId="{0D250578-30A5-42D4-8C88-BF27776B7108}" dt="2023-06-06T06:58:41.654" v="5706" actId="1076"/>
          <ac:picMkLst>
            <pc:docMk/>
            <pc:sldMk cId="3678178586" sldId="269"/>
            <ac:picMk id="13" creationId="{338E4172-878E-422A-BEB4-2A3C1CDB24A2}"/>
          </ac:picMkLst>
        </pc:picChg>
        <pc:picChg chg="del">
          <ac:chgData name="Mintzas, Konstantinos - SEG" userId="8c131287-7383-4bd1-a38f-81a83fd893f4" providerId="ADAL" clId="{0D250578-30A5-42D4-8C88-BF27776B7108}" dt="2023-06-05T11:22:42.741" v="5582" actId="478"/>
          <ac:picMkLst>
            <pc:docMk/>
            <pc:sldMk cId="3678178586" sldId="269"/>
            <ac:picMk id="13" creationId="{BD93FAE0-FC83-46D4-AEA5-C2CAB9782742}"/>
          </ac:picMkLst>
        </pc:picChg>
        <pc:picChg chg="add mod ord">
          <ac:chgData name="Mintzas, Konstantinos - SEG" userId="8c131287-7383-4bd1-a38f-81a83fd893f4" providerId="ADAL" clId="{0D250578-30A5-42D4-8C88-BF27776B7108}" dt="2023-06-06T06:58:32.989" v="5705" actId="1076"/>
          <ac:picMkLst>
            <pc:docMk/>
            <pc:sldMk cId="3678178586" sldId="269"/>
            <ac:picMk id="15" creationId="{5D8B2F1F-3611-4A1B-8CFE-DC18E84DD67F}"/>
          </ac:picMkLst>
        </pc:picChg>
        <pc:picChg chg="del">
          <ac:chgData name="Mintzas, Konstantinos - SEG" userId="8c131287-7383-4bd1-a38f-81a83fd893f4" providerId="ADAL" clId="{0D250578-30A5-42D4-8C88-BF27776B7108}" dt="2023-06-05T11:22:42.741" v="5582" actId="478"/>
          <ac:picMkLst>
            <pc:docMk/>
            <pc:sldMk cId="3678178586" sldId="269"/>
            <ac:picMk id="15" creationId="{68CA0BFD-C9A0-4F44-A95C-E773DD233699}"/>
          </ac:picMkLst>
        </pc:picChg>
        <pc:picChg chg="del">
          <ac:chgData name="Mintzas, Konstantinos - SEG" userId="8c131287-7383-4bd1-a38f-81a83fd893f4" providerId="ADAL" clId="{0D250578-30A5-42D4-8C88-BF27776B7108}" dt="2023-06-05T11:22:42.741" v="5582" actId="478"/>
          <ac:picMkLst>
            <pc:docMk/>
            <pc:sldMk cId="3678178586" sldId="269"/>
            <ac:picMk id="17" creationId="{1CAC0511-AAF2-4891-B533-46689A3BED01}"/>
          </ac:picMkLst>
        </pc:picChg>
        <pc:picChg chg="add mod ord">
          <ac:chgData name="Mintzas, Konstantinos - SEG" userId="8c131287-7383-4bd1-a38f-81a83fd893f4" providerId="ADAL" clId="{0D250578-30A5-42D4-8C88-BF27776B7108}" dt="2023-06-06T06:58:22.155" v="5704" actId="1076"/>
          <ac:picMkLst>
            <pc:docMk/>
            <pc:sldMk cId="3678178586" sldId="269"/>
            <ac:picMk id="17" creationId="{82DA4C0D-B2EE-4399-9B2F-0A6B6C34F3D1}"/>
          </ac:picMkLst>
        </pc:picChg>
        <pc:picChg chg="add mod ord">
          <ac:chgData name="Mintzas, Konstantinos - SEG" userId="8c131287-7383-4bd1-a38f-81a83fd893f4" providerId="ADAL" clId="{0D250578-30A5-42D4-8C88-BF27776B7108}" dt="2023-06-06T07:29:58.830" v="5713" actId="1076"/>
          <ac:picMkLst>
            <pc:docMk/>
            <pc:sldMk cId="3678178586" sldId="269"/>
            <ac:picMk id="19" creationId="{0CF89EAC-20E4-4231-92D6-2030AB27417B}"/>
          </ac:picMkLst>
        </pc:picChg>
        <pc:picChg chg="del">
          <ac:chgData name="Mintzas, Konstantinos - SEG" userId="8c131287-7383-4bd1-a38f-81a83fd893f4" providerId="ADAL" clId="{0D250578-30A5-42D4-8C88-BF27776B7108}" dt="2023-06-05T11:22:42.741" v="5582" actId="478"/>
          <ac:picMkLst>
            <pc:docMk/>
            <pc:sldMk cId="3678178586" sldId="269"/>
            <ac:picMk id="19" creationId="{98857093-789A-42C0-A470-409CDFA9333D}"/>
          </ac:picMkLst>
        </pc:picChg>
        <pc:picChg chg="del">
          <ac:chgData name="Mintzas, Konstantinos - SEG" userId="8c131287-7383-4bd1-a38f-81a83fd893f4" providerId="ADAL" clId="{0D250578-30A5-42D4-8C88-BF27776B7108}" dt="2023-06-05T11:22:42.741" v="5582" actId="478"/>
          <ac:picMkLst>
            <pc:docMk/>
            <pc:sldMk cId="3678178586" sldId="269"/>
            <ac:picMk id="21" creationId="{0A185AED-1E98-4351-B05B-CFD1668FE524}"/>
          </ac:picMkLst>
        </pc:picChg>
        <pc:picChg chg="add mod ord">
          <ac:chgData name="Mintzas, Konstantinos - SEG" userId="8c131287-7383-4bd1-a38f-81a83fd893f4" providerId="ADAL" clId="{0D250578-30A5-42D4-8C88-BF27776B7108}" dt="2023-06-06T07:29:52.802" v="5712" actId="1076"/>
          <ac:picMkLst>
            <pc:docMk/>
            <pc:sldMk cId="3678178586" sldId="269"/>
            <ac:picMk id="21" creationId="{5D6B4CD3-83DB-4A64-A921-D7C070985C98}"/>
          </ac:picMkLst>
        </pc:picChg>
        <pc:picChg chg="add mod ord">
          <ac:chgData name="Mintzas, Konstantinos - SEG" userId="8c131287-7383-4bd1-a38f-81a83fd893f4" providerId="ADAL" clId="{0D250578-30A5-42D4-8C88-BF27776B7108}" dt="2023-06-06T07:29:37.735" v="5711" actId="1076"/>
          <ac:picMkLst>
            <pc:docMk/>
            <pc:sldMk cId="3678178586" sldId="269"/>
            <ac:picMk id="23" creationId="{2A728D4A-5000-4FD3-80AF-91E8ECC3777D}"/>
          </ac:picMkLst>
        </pc:picChg>
        <pc:picChg chg="del">
          <ac:chgData name="Mintzas, Konstantinos - SEG" userId="8c131287-7383-4bd1-a38f-81a83fd893f4" providerId="ADAL" clId="{0D250578-30A5-42D4-8C88-BF27776B7108}" dt="2023-06-05T11:22:42.741" v="5582" actId="478"/>
          <ac:picMkLst>
            <pc:docMk/>
            <pc:sldMk cId="3678178586" sldId="269"/>
            <ac:picMk id="23" creationId="{BA743780-84F2-45DF-9618-585141006263}"/>
          </ac:picMkLst>
        </pc:picChg>
        <pc:picChg chg="add mod ord">
          <ac:chgData name="Mintzas, Konstantinos - SEG" userId="8c131287-7383-4bd1-a38f-81a83fd893f4" providerId="ADAL" clId="{0D250578-30A5-42D4-8C88-BF27776B7108}" dt="2023-06-06T07:40:55.534" v="5720" actId="1076"/>
          <ac:picMkLst>
            <pc:docMk/>
            <pc:sldMk cId="3678178586" sldId="269"/>
            <ac:picMk id="25" creationId="{3FAC30EC-EB7C-427E-8B5A-1DC42A1B297F}"/>
          </ac:picMkLst>
        </pc:picChg>
        <pc:picChg chg="del">
          <ac:chgData name="Mintzas, Konstantinos - SEG" userId="8c131287-7383-4bd1-a38f-81a83fd893f4" providerId="ADAL" clId="{0D250578-30A5-42D4-8C88-BF27776B7108}" dt="2023-06-05T11:22:42.741" v="5582" actId="478"/>
          <ac:picMkLst>
            <pc:docMk/>
            <pc:sldMk cId="3678178586" sldId="269"/>
            <ac:picMk id="25" creationId="{7F956362-4159-4720-AFE6-880B4AED03D6}"/>
          </ac:picMkLst>
        </pc:picChg>
        <pc:picChg chg="del">
          <ac:chgData name="Mintzas, Konstantinos - SEG" userId="8c131287-7383-4bd1-a38f-81a83fd893f4" providerId="ADAL" clId="{0D250578-30A5-42D4-8C88-BF27776B7108}" dt="2023-06-05T11:22:42.741" v="5582" actId="478"/>
          <ac:picMkLst>
            <pc:docMk/>
            <pc:sldMk cId="3678178586" sldId="269"/>
            <ac:picMk id="27" creationId="{86C8944C-8720-4ACE-BAB4-FFFEA55CC626}"/>
          </ac:picMkLst>
        </pc:picChg>
        <pc:picChg chg="add mod ord">
          <ac:chgData name="Mintzas, Konstantinos - SEG" userId="8c131287-7383-4bd1-a38f-81a83fd893f4" providerId="ADAL" clId="{0D250578-30A5-42D4-8C88-BF27776B7108}" dt="2023-06-06T07:40:46.884" v="5719" actId="1076"/>
          <ac:picMkLst>
            <pc:docMk/>
            <pc:sldMk cId="3678178586" sldId="269"/>
            <ac:picMk id="27" creationId="{AE4E90B2-E1CC-47EF-A436-54A9CA246F7A}"/>
          </ac:picMkLst>
        </pc:picChg>
        <pc:picChg chg="add mod ord">
          <ac:chgData name="Mintzas, Konstantinos - SEG" userId="8c131287-7383-4bd1-a38f-81a83fd893f4" providerId="ADAL" clId="{0D250578-30A5-42D4-8C88-BF27776B7108}" dt="2023-06-06T07:40:41.369" v="5718" actId="1076"/>
          <ac:picMkLst>
            <pc:docMk/>
            <pc:sldMk cId="3678178586" sldId="269"/>
            <ac:picMk id="29" creationId="{292F6684-D6C7-433E-81BC-7F4A4E9A0985}"/>
          </ac:picMkLst>
        </pc:picChg>
        <pc:picChg chg="del">
          <ac:chgData name="Mintzas, Konstantinos - SEG" userId="8c131287-7383-4bd1-a38f-81a83fd893f4" providerId="ADAL" clId="{0D250578-30A5-42D4-8C88-BF27776B7108}" dt="2023-06-05T11:22:42.741" v="5582" actId="478"/>
          <ac:picMkLst>
            <pc:docMk/>
            <pc:sldMk cId="3678178586" sldId="269"/>
            <ac:picMk id="29" creationId="{388F3335-9C09-43E8-BD29-5342975B12D5}"/>
          </ac:picMkLst>
        </pc:picChg>
      </pc:sldChg>
      <pc:sldChg chg="addSp modSp new mod">
        <pc:chgData name="Mintzas, Konstantinos - SEG" userId="8c131287-7383-4bd1-a38f-81a83fd893f4" providerId="ADAL" clId="{0D250578-30A5-42D4-8C88-BF27776B7108}" dt="2023-06-14T07:47:05.259" v="6584" actId="20577"/>
        <pc:sldMkLst>
          <pc:docMk/>
          <pc:sldMk cId="933156335" sldId="270"/>
        </pc:sldMkLst>
        <pc:spChg chg="add mod">
          <ac:chgData name="Mintzas, Konstantinos - SEG" userId="8c131287-7383-4bd1-a38f-81a83fd893f4" providerId="ADAL" clId="{0D250578-30A5-42D4-8C88-BF27776B7108}" dt="2023-06-14T07:47:05.259" v="6584" actId="20577"/>
          <ac:spMkLst>
            <pc:docMk/>
            <pc:sldMk cId="933156335" sldId="270"/>
            <ac:spMk id="2" creationId="{8FD1F06E-C9AA-441C-973A-D61A9E2B8453}"/>
          </ac:spMkLst>
        </pc:spChg>
        <pc:spChg chg="add mod">
          <ac:chgData name="Mintzas, Konstantinos - SEG" userId="8c131287-7383-4bd1-a38f-81a83fd893f4" providerId="ADAL" clId="{0D250578-30A5-42D4-8C88-BF27776B7108}" dt="2023-06-07T07:37:19.362" v="5970"/>
          <ac:spMkLst>
            <pc:docMk/>
            <pc:sldMk cId="933156335" sldId="270"/>
            <ac:spMk id="4" creationId="{14C7F2A5-714F-47D0-A76C-EA9A8AD61CD8}"/>
          </ac:spMkLst>
        </pc:spChg>
        <pc:spChg chg="add mod">
          <ac:chgData name="Mintzas, Konstantinos - SEG" userId="8c131287-7383-4bd1-a38f-81a83fd893f4" providerId="ADAL" clId="{0D250578-30A5-42D4-8C88-BF27776B7108}" dt="2023-06-07T07:38:22.066" v="6008" actId="1076"/>
          <ac:spMkLst>
            <pc:docMk/>
            <pc:sldMk cId="933156335" sldId="270"/>
            <ac:spMk id="5" creationId="{B14C4C9D-5B14-4F4E-8354-6514095C6F8D}"/>
          </ac:spMkLst>
        </pc:spChg>
        <pc:spChg chg="add mod">
          <ac:chgData name="Mintzas, Konstantinos - SEG" userId="8c131287-7383-4bd1-a38f-81a83fd893f4" providerId="ADAL" clId="{0D250578-30A5-42D4-8C88-BF27776B7108}" dt="2023-06-14T06:14:13.808" v="6183" actId="1076"/>
          <ac:spMkLst>
            <pc:docMk/>
            <pc:sldMk cId="933156335" sldId="270"/>
            <ac:spMk id="6" creationId="{381150AF-4075-46FA-9777-F3301662C118}"/>
          </ac:spMkLst>
        </pc:spChg>
        <pc:spChg chg="add mod">
          <ac:chgData name="Mintzas, Konstantinos - SEG" userId="8c131287-7383-4bd1-a38f-81a83fd893f4" providerId="ADAL" clId="{0D250578-30A5-42D4-8C88-BF27776B7108}" dt="2023-06-07T07:37:43.466" v="5997" actId="20577"/>
          <ac:spMkLst>
            <pc:docMk/>
            <pc:sldMk cId="933156335" sldId="270"/>
            <ac:spMk id="7" creationId="{27568697-C4D4-4D33-BB06-4BCF99D08732}"/>
          </ac:spMkLst>
        </pc:spChg>
        <pc:spChg chg="add mod">
          <ac:chgData name="Mintzas, Konstantinos - SEG" userId="8c131287-7383-4bd1-a38f-81a83fd893f4" providerId="ADAL" clId="{0D250578-30A5-42D4-8C88-BF27776B7108}" dt="2023-06-14T07:45:23.673" v="6458" actId="20577"/>
          <ac:spMkLst>
            <pc:docMk/>
            <pc:sldMk cId="933156335" sldId="270"/>
            <ac:spMk id="11" creationId="{961071D5-0E59-4DD9-88F2-4D920B511A5A}"/>
          </ac:spMkLst>
        </pc:spChg>
        <pc:spChg chg="add mod">
          <ac:chgData name="Mintzas, Konstantinos - SEG" userId="8c131287-7383-4bd1-a38f-81a83fd893f4" providerId="ADAL" clId="{0D250578-30A5-42D4-8C88-BF27776B7108}" dt="2023-06-07T07:38:39.661" v="6012" actId="1076"/>
          <ac:spMkLst>
            <pc:docMk/>
            <pc:sldMk cId="933156335" sldId="270"/>
            <ac:spMk id="13" creationId="{1880C785-DEE7-4F2D-A74A-BD7A8D21CF19}"/>
          </ac:spMkLst>
        </pc:spChg>
        <pc:spChg chg="add mod">
          <ac:chgData name="Mintzas, Konstantinos - SEG" userId="8c131287-7383-4bd1-a38f-81a83fd893f4" providerId="ADAL" clId="{0D250578-30A5-42D4-8C88-BF27776B7108}" dt="2023-06-07T07:38:39.661" v="6012" actId="1076"/>
          <ac:spMkLst>
            <pc:docMk/>
            <pc:sldMk cId="933156335" sldId="270"/>
            <ac:spMk id="14" creationId="{D0917230-A709-499D-A55C-3C8D68CFAE52}"/>
          </ac:spMkLst>
        </pc:spChg>
        <pc:picChg chg="add mod">
          <ac:chgData name="Mintzas, Konstantinos - SEG" userId="8c131287-7383-4bd1-a38f-81a83fd893f4" providerId="ADAL" clId="{0D250578-30A5-42D4-8C88-BF27776B7108}" dt="2023-06-07T07:37:12.938" v="5969" actId="1076"/>
          <ac:picMkLst>
            <pc:docMk/>
            <pc:sldMk cId="933156335" sldId="270"/>
            <ac:picMk id="3" creationId="{D65530BF-C77D-4585-867D-CE499CA8E427}"/>
          </ac:picMkLst>
        </pc:picChg>
        <pc:picChg chg="add mod">
          <ac:chgData name="Mintzas, Konstantinos - SEG" userId="8c131287-7383-4bd1-a38f-81a83fd893f4" providerId="ADAL" clId="{0D250578-30A5-42D4-8C88-BF27776B7108}" dt="2023-06-07T07:37:53.673" v="6000" actId="14100"/>
          <ac:picMkLst>
            <pc:docMk/>
            <pc:sldMk cId="933156335" sldId="270"/>
            <ac:picMk id="8" creationId="{B176E89B-401F-4058-8993-186B89F7E65F}"/>
          </ac:picMkLst>
        </pc:picChg>
        <pc:picChg chg="add mod">
          <ac:chgData name="Mintzas, Konstantinos - SEG" userId="8c131287-7383-4bd1-a38f-81a83fd893f4" providerId="ADAL" clId="{0D250578-30A5-42D4-8C88-BF27776B7108}" dt="2023-06-07T07:38:06.491" v="6004" actId="1076"/>
          <ac:picMkLst>
            <pc:docMk/>
            <pc:sldMk cId="933156335" sldId="270"/>
            <ac:picMk id="9" creationId="{D1C3BDC4-D7AE-4776-B38A-7AF865F2142C}"/>
          </ac:picMkLst>
        </pc:picChg>
        <pc:picChg chg="add mod">
          <ac:chgData name="Mintzas, Konstantinos - SEG" userId="8c131287-7383-4bd1-a38f-81a83fd893f4" providerId="ADAL" clId="{0D250578-30A5-42D4-8C88-BF27776B7108}" dt="2023-06-07T07:38:18.539" v="6007" actId="1076"/>
          <ac:picMkLst>
            <pc:docMk/>
            <pc:sldMk cId="933156335" sldId="270"/>
            <ac:picMk id="10" creationId="{B8D1B630-B6F4-4E71-9187-D4A07149BDCA}"/>
          </ac:picMkLst>
        </pc:picChg>
        <pc:picChg chg="add mod">
          <ac:chgData name="Mintzas, Konstantinos - SEG" userId="8c131287-7383-4bd1-a38f-81a83fd893f4" providerId="ADAL" clId="{0D250578-30A5-42D4-8C88-BF27776B7108}" dt="2023-06-07T07:38:39.661" v="6012" actId="1076"/>
          <ac:picMkLst>
            <pc:docMk/>
            <pc:sldMk cId="933156335" sldId="270"/>
            <ac:picMk id="12" creationId="{94E295F6-5AC6-40EB-868C-E403858784F2}"/>
          </ac:picMkLst>
        </pc:picChg>
        <pc:picChg chg="add mod">
          <ac:chgData name="Mintzas, Konstantinos - SEG" userId="8c131287-7383-4bd1-a38f-81a83fd893f4" providerId="ADAL" clId="{0D250578-30A5-42D4-8C88-BF27776B7108}" dt="2023-06-07T07:38:39.661" v="6012" actId="1076"/>
          <ac:picMkLst>
            <pc:docMk/>
            <pc:sldMk cId="933156335" sldId="270"/>
            <ac:picMk id="15" creationId="{BD78FABC-D48F-4D7D-A4B6-37F427A959A2}"/>
          </ac:picMkLst>
        </pc:picChg>
        <pc:picChg chg="add mod">
          <ac:chgData name="Mintzas, Konstantinos - SEG" userId="8c131287-7383-4bd1-a38f-81a83fd893f4" providerId="ADAL" clId="{0D250578-30A5-42D4-8C88-BF27776B7108}" dt="2023-06-07T07:38:39.661" v="6012" actId="1076"/>
          <ac:picMkLst>
            <pc:docMk/>
            <pc:sldMk cId="933156335" sldId="270"/>
            <ac:picMk id="16" creationId="{1EAAC67D-359B-45DC-A059-46456E65DD18}"/>
          </ac:picMkLst>
        </pc:picChg>
      </pc:sldChg>
      <pc:sldChg chg="addSp modSp add del mod addCm delCm">
        <pc:chgData name="Mintzas, Konstantinos - SEG" userId="8c131287-7383-4bd1-a38f-81a83fd893f4" providerId="ADAL" clId="{0D250578-30A5-42D4-8C88-BF27776B7108}" dt="2023-06-07T07:56:45.042" v="6129" actId="47"/>
        <pc:sldMkLst>
          <pc:docMk/>
          <pc:sldMk cId="333625967" sldId="271"/>
        </pc:sldMkLst>
        <pc:spChg chg="mod">
          <ac:chgData name="Mintzas, Konstantinos - SEG" userId="8c131287-7383-4bd1-a38f-81a83fd893f4" providerId="ADAL" clId="{0D250578-30A5-42D4-8C88-BF27776B7108}" dt="2023-06-07T07:34:09.755" v="5965" actId="14100"/>
          <ac:spMkLst>
            <pc:docMk/>
            <pc:sldMk cId="333625967" sldId="271"/>
            <ac:spMk id="2" creationId="{8FD1F06E-C9AA-441C-973A-D61A9E2B8453}"/>
          </ac:spMkLst>
        </pc:spChg>
        <pc:spChg chg="add mod">
          <ac:chgData name="Mintzas, Konstantinos - SEG" userId="8c131287-7383-4bd1-a38f-81a83fd893f4" providerId="ADAL" clId="{0D250578-30A5-42D4-8C88-BF27776B7108}" dt="2023-06-07T07:33:18.098" v="5941" actId="1076"/>
          <ac:spMkLst>
            <pc:docMk/>
            <pc:sldMk cId="333625967" sldId="271"/>
            <ac:spMk id="4" creationId="{3DD0BC33-91C3-47C9-A875-D4D5729010A9}"/>
          </ac:spMkLst>
        </pc:spChg>
        <pc:spChg chg="add mod">
          <ac:chgData name="Mintzas, Konstantinos - SEG" userId="8c131287-7383-4bd1-a38f-81a83fd893f4" providerId="ADAL" clId="{0D250578-30A5-42D4-8C88-BF27776B7108}" dt="2023-06-07T07:33:23.649" v="5950" actId="20577"/>
          <ac:spMkLst>
            <pc:docMk/>
            <pc:sldMk cId="333625967" sldId="271"/>
            <ac:spMk id="5" creationId="{F0D3C460-2DD9-4369-BECE-70512C8B20DD}"/>
          </ac:spMkLst>
        </pc:spChg>
        <pc:picChg chg="add mod modCrop">
          <ac:chgData name="Mintzas, Konstantinos - SEG" userId="8c131287-7383-4bd1-a38f-81a83fd893f4" providerId="ADAL" clId="{0D250578-30A5-42D4-8C88-BF27776B7108}" dt="2023-06-07T07:32:41.826" v="5925" actId="1076"/>
          <ac:picMkLst>
            <pc:docMk/>
            <pc:sldMk cId="333625967" sldId="271"/>
            <ac:picMk id="3" creationId="{DA6D9E83-3C2B-485B-8A7A-31FD89F6C372}"/>
          </ac:picMkLst>
        </pc:picChg>
        <pc:picChg chg="add mod">
          <ac:chgData name="Mintzas, Konstantinos - SEG" userId="8c131287-7383-4bd1-a38f-81a83fd893f4" providerId="ADAL" clId="{0D250578-30A5-42D4-8C88-BF27776B7108}" dt="2023-06-07T07:33:41.490" v="5956" actId="1076"/>
          <ac:picMkLst>
            <pc:docMk/>
            <pc:sldMk cId="333625967" sldId="271"/>
            <ac:picMk id="6" creationId="{40D3DBF0-1E70-4441-9AC8-E81FCCCC3EA0}"/>
          </ac:picMkLst>
        </pc:picChg>
        <pc:picChg chg="add mod">
          <ac:chgData name="Mintzas, Konstantinos - SEG" userId="8c131287-7383-4bd1-a38f-81a83fd893f4" providerId="ADAL" clId="{0D250578-30A5-42D4-8C88-BF27776B7108}" dt="2023-06-07T07:33:59.970" v="5963" actId="14100"/>
          <ac:picMkLst>
            <pc:docMk/>
            <pc:sldMk cId="333625967" sldId="271"/>
            <ac:picMk id="7" creationId="{94121A83-C983-4FCB-AC72-78B0622E3D3D}"/>
          </ac:picMkLst>
        </pc:picChg>
      </pc:sldChg>
      <pc:sldChg chg="addSp modSp new del mod">
        <pc:chgData name="Mintzas, Konstantinos - SEG" userId="8c131287-7383-4bd1-a38f-81a83fd893f4" providerId="ADAL" clId="{0D250578-30A5-42D4-8C88-BF27776B7108}" dt="2023-06-14T09:34:33.041" v="6585" actId="47"/>
        <pc:sldMkLst>
          <pc:docMk/>
          <pc:sldMk cId="1803978804" sldId="271"/>
        </pc:sldMkLst>
        <pc:graphicFrameChg chg="add mod modGraphic">
          <ac:chgData name="Mintzas, Konstantinos - SEG" userId="8c131287-7383-4bd1-a38f-81a83fd893f4" providerId="ADAL" clId="{0D250578-30A5-42D4-8C88-BF27776B7108}" dt="2023-06-07T08:21:46.695" v="6158" actId="2084"/>
          <ac:graphicFrameMkLst>
            <pc:docMk/>
            <pc:sldMk cId="1803978804" sldId="271"/>
            <ac:graphicFrameMk id="2" creationId="{C2D3D51A-08B2-4B48-AAA1-A9837C4C904B}"/>
          </ac:graphicFrameMkLst>
        </pc:graphicFrameChg>
        <pc:graphicFrameChg chg="add mod modGraphic">
          <ac:chgData name="Mintzas, Konstantinos - SEG" userId="8c131287-7383-4bd1-a38f-81a83fd893f4" providerId="ADAL" clId="{0D250578-30A5-42D4-8C88-BF27776B7108}" dt="2023-06-07T08:21:23.513" v="6157" actId="207"/>
          <ac:graphicFrameMkLst>
            <pc:docMk/>
            <pc:sldMk cId="1803978804" sldId="271"/>
            <ac:graphicFrameMk id="3" creationId="{C33E99A6-214F-482C-B476-0272D06EFBE2}"/>
          </ac:graphicFrameMkLst>
        </pc:graphicFrameChg>
      </pc:sldChg>
      <pc:sldMasterChg chg="addSp modSp mod">
        <pc:chgData name="Mintzas, Konstantinos - SEG" userId="8c131287-7383-4bd1-a38f-81a83fd893f4" providerId="ADAL" clId="{0D250578-30A5-42D4-8C88-BF27776B7108}" dt="2023-05-24T15:38:41.362" v="1954"/>
        <pc:sldMasterMkLst>
          <pc:docMk/>
          <pc:sldMasterMk cId="1569285401" sldId="2147483660"/>
        </pc:sldMasterMkLst>
        <pc:spChg chg="add mod ord modVis">
          <ac:chgData name="Mintzas, Konstantinos - SEG" userId="8c131287-7383-4bd1-a38f-81a83fd893f4" providerId="ADAL" clId="{0D250578-30A5-42D4-8C88-BF27776B7108}" dt="2023-05-24T15:38:41.362" v="1954"/>
          <ac:spMkLst>
            <pc:docMk/>
            <pc:sldMasterMk cId="1569285401" sldId="2147483660"/>
            <ac:spMk id="7" creationId="{35536343-9AD9-4A61-9257-CE8EAFBC8FA6}"/>
          </ac:spMkLst>
        </pc:spChg>
      </pc:sldMasterChg>
    </pc:docChg>
  </pc:docChgLst>
  <pc:docChgLst>
    <pc:chgData name="Mintzas, Konstantinos - SEG" userId="8c131287-7383-4bd1-a38f-81a83fd893f4" providerId="ADAL" clId="{FFF9BB25-A791-4768-9973-59064577EAE0}"/>
    <pc:docChg chg="delSld">
      <pc:chgData name="Mintzas, Konstantinos - SEG" userId="8c131287-7383-4bd1-a38f-81a83fd893f4" providerId="ADAL" clId="{FFF9BB25-A791-4768-9973-59064577EAE0}" dt="2023-06-26T11:02:23.275" v="0" actId="47"/>
      <pc:docMkLst>
        <pc:docMk/>
      </pc:docMkLst>
      <pc:sldChg chg="del">
        <pc:chgData name="Mintzas, Konstantinos - SEG" userId="8c131287-7383-4bd1-a38f-81a83fd893f4" providerId="ADAL" clId="{FFF9BB25-A791-4768-9973-59064577EAE0}" dt="2023-06-26T11:02:23.275" v="0" actId="47"/>
        <pc:sldMkLst>
          <pc:docMk/>
          <pc:sldMk cId="2171268508" sldId="264"/>
        </pc:sldMkLst>
      </pc:sldChg>
      <pc:sldChg chg="del">
        <pc:chgData name="Mintzas, Konstantinos - SEG" userId="8c131287-7383-4bd1-a38f-81a83fd893f4" providerId="ADAL" clId="{FFF9BB25-A791-4768-9973-59064577EAE0}" dt="2023-06-26T11:02:23.275" v="0" actId="47"/>
        <pc:sldMkLst>
          <pc:docMk/>
          <pc:sldMk cId="1911772757" sldId="265"/>
        </pc:sldMkLst>
      </pc:sldChg>
      <pc:sldChg chg="del">
        <pc:chgData name="Mintzas, Konstantinos - SEG" userId="8c131287-7383-4bd1-a38f-81a83fd893f4" providerId="ADAL" clId="{FFF9BB25-A791-4768-9973-59064577EAE0}" dt="2023-06-26T11:02:23.275" v="0" actId="47"/>
        <pc:sldMkLst>
          <pc:docMk/>
          <pc:sldMk cId="713077976" sldId="266"/>
        </pc:sldMkLst>
      </pc:sldChg>
    </pc:docChg>
  </pc:docChgLst>
  <pc:docChgLst>
    <pc:chgData name="Mintzas, Konstantinos - SEG" userId="8c131287-7383-4bd1-a38f-81a83fd893f4" providerId="ADAL" clId="{99846C27-5E9A-4519-8735-B937006E8464}"/>
    <pc:docChg chg="custSel delSld modMainMaster">
      <pc:chgData name="Mintzas, Konstantinos - SEG" userId="8c131287-7383-4bd1-a38f-81a83fd893f4" providerId="ADAL" clId="{99846C27-5E9A-4519-8735-B937006E8464}" dt="2023-11-16T09:28:35.712" v="3"/>
      <pc:docMkLst>
        <pc:docMk/>
      </pc:docMkLst>
      <pc:sldChg chg="del">
        <pc:chgData name="Mintzas, Konstantinos - SEG" userId="8c131287-7383-4bd1-a38f-81a83fd893f4" providerId="ADAL" clId="{99846C27-5E9A-4519-8735-B937006E8464}" dt="2023-11-16T09:28:14.422" v="0" actId="47"/>
        <pc:sldMkLst>
          <pc:docMk/>
          <pc:sldMk cId="488937180" sldId="256"/>
        </pc:sldMkLst>
      </pc:sldChg>
      <pc:sldChg chg="del">
        <pc:chgData name="Mintzas, Konstantinos - SEG" userId="8c131287-7383-4bd1-a38f-81a83fd893f4" providerId="ADAL" clId="{99846C27-5E9A-4519-8735-B937006E8464}" dt="2023-11-16T09:28:14.422" v="0" actId="47"/>
        <pc:sldMkLst>
          <pc:docMk/>
          <pc:sldMk cId="823654777" sldId="257"/>
        </pc:sldMkLst>
      </pc:sldChg>
      <pc:sldChg chg="del">
        <pc:chgData name="Mintzas, Konstantinos - SEG" userId="8c131287-7383-4bd1-a38f-81a83fd893f4" providerId="ADAL" clId="{99846C27-5E9A-4519-8735-B937006E8464}" dt="2023-11-16T09:28:14.422" v="0" actId="47"/>
        <pc:sldMkLst>
          <pc:docMk/>
          <pc:sldMk cId="2346725106" sldId="258"/>
        </pc:sldMkLst>
      </pc:sldChg>
      <pc:sldChg chg="del">
        <pc:chgData name="Mintzas, Konstantinos - SEG" userId="8c131287-7383-4bd1-a38f-81a83fd893f4" providerId="ADAL" clId="{99846C27-5E9A-4519-8735-B937006E8464}" dt="2023-11-16T09:28:16.925" v="1" actId="47"/>
        <pc:sldMkLst>
          <pc:docMk/>
          <pc:sldMk cId="900528703" sldId="261"/>
        </pc:sldMkLst>
      </pc:sldChg>
      <pc:sldChg chg="del">
        <pc:chgData name="Mintzas, Konstantinos - SEG" userId="8c131287-7383-4bd1-a38f-81a83fd893f4" providerId="ADAL" clId="{99846C27-5E9A-4519-8735-B937006E8464}" dt="2023-11-16T09:28:16.925" v="1" actId="47"/>
        <pc:sldMkLst>
          <pc:docMk/>
          <pc:sldMk cId="3393704244" sldId="262"/>
        </pc:sldMkLst>
      </pc:sldChg>
      <pc:sldChg chg="del">
        <pc:chgData name="Mintzas, Konstantinos - SEG" userId="8c131287-7383-4bd1-a38f-81a83fd893f4" providerId="ADAL" clId="{99846C27-5E9A-4519-8735-B937006E8464}" dt="2023-11-16T09:28:16.925" v="1" actId="47"/>
        <pc:sldMkLst>
          <pc:docMk/>
          <pc:sldMk cId="1402241650" sldId="263"/>
        </pc:sldMkLst>
      </pc:sldChg>
      <pc:sldChg chg="del">
        <pc:chgData name="Mintzas, Konstantinos - SEG" userId="8c131287-7383-4bd1-a38f-81a83fd893f4" providerId="ADAL" clId="{99846C27-5E9A-4519-8735-B937006E8464}" dt="2023-11-16T09:28:14.422" v="0" actId="47"/>
        <pc:sldMkLst>
          <pc:docMk/>
          <pc:sldMk cId="2737034867" sldId="267"/>
        </pc:sldMkLst>
      </pc:sldChg>
      <pc:sldChg chg="del">
        <pc:chgData name="Mintzas, Konstantinos - SEG" userId="8c131287-7383-4bd1-a38f-81a83fd893f4" providerId="ADAL" clId="{99846C27-5E9A-4519-8735-B937006E8464}" dt="2023-11-16T09:28:16.925" v="1" actId="47"/>
        <pc:sldMkLst>
          <pc:docMk/>
          <pc:sldMk cId="300474881" sldId="268"/>
        </pc:sldMkLst>
      </pc:sldChg>
      <pc:sldChg chg="del">
        <pc:chgData name="Mintzas, Konstantinos - SEG" userId="8c131287-7383-4bd1-a38f-81a83fd893f4" providerId="ADAL" clId="{99846C27-5E9A-4519-8735-B937006E8464}" dt="2023-11-16T09:28:16.925" v="1" actId="47"/>
        <pc:sldMkLst>
          <pc:docMk/>
          <pc:sldMk cId="3678178586" sldId="269"/>
        </pc:sldMkLst>
      </pc:sldChg>
      <pc:sldChg chg="del">
        <pc:chgData name="Mintzas, Konstantinos - SEG" userId="8c131287-7383-4bd1-a38f-81a83fd893f4" providerId="ADAL" clId="{99846C27-5E9A-4519-8735-B937006E8464}" dt="2023-11-16T09:28:16.925" v="1" actId="47"/>
        <pc:sldMkLst>
          <pc:docMk/>
          <pc:sldMk cId="933156335" sldId="270"/>
        </pc:sldMkLst>
      </pc:sldChg>
      <pc:sldMasterChg chg="delSp mod">
        <pc:chgData name="Mintzas, Konstantinos - SEG" userId="8c131287-7383-4bd1-a38f-81a83fd893f4" providerId="ADAL" clId="{99846C27-5E9A-4519-8735-B937006E8464}" dt="2023-11-16T09:28:35.712" v="3"/>
        <pc:sldMasterMkLst>
          <pc:docMk/>
          <pc:sldMasterMk cId="1569285401" sldId="2147483660"/>
        </pc:sldMasterMkLst>
        <pc:spChg chg="del">
          <ac:chgData name="Mintzas, Konstantinos - SEG" userId="8c131287-7383-4bd1-a38f-81a83fd893f4" providerId="ADAL" clId="{99846C27-5E9A-4519-8735-B937006E8464}" dt="2023-11-16T09:28:35.712" v="3"/>
          <ac:spMkLst>
            <pc:docMk/>
            <pc:sldMasterMk cId="1569285401" sldId="2147483660"/>
            <ac:spMk id="7" creationId="{35536343-9AD9-4A61-9257-CE8EAFBC8FA6}"/>
          </ac:spMkLst>
        </pc:spChg>
      </pc:sldMasterChg>
    </pc:docChg>
  </pc:docChgLst>
  <pc:docChgLst>
    <pc:chgData name="Mintzas, Konstantinos - SEG" userId="8c131287-7383-4bd1-a38f-81a83fd893f4" providerId="ADAL" clId="{159B6597-488D-4263-B2E4-21C3224D6CCE}"/>
    <pc:docChg chg="custSel modSld sldOrd">
      <pc:chgData name="Mintzas, Konstantinos - SEG" userId="8c131287-7383-4bd1-a38f-81a83fd893f4" providerId="ADAL" clId="{159B6597-488D-4263-B2E4-21C3224D6CCE}" dt="2023-09-22T12:43:33.325" v="13" actId="20577"/>
      <pc:docMkLst>
        <pc:docMk/>
      </pc:docMkLst>
      <pc:sldChg chg="modSp mod ord">
        <pc:chgData name="Mintzas, Konstantinos - SEG" userId="8c131287-7383-4bd1-a38f-81a83fd893f4" providerId="ADAL" clId="{159B6597-488D-4263-B2E4-21C3224D6CCE}" dt="2023-09-22T12:43:19.327" v="7" actId="20577"/>
        <pc:sldMkLst>
          <pc:docMk/>
          <pc:sldMk cId="1402241650" sldId="263"/>
        </pc:sldMkLst>
        <pc:spChg chg="mod">
          <ac:chgData name="Mintzas, Konstantinos - SEG" userId="8c131287-7383-4bd1-a38f-81a83fd893f4" providerId="ADAL" clId="{159B6597-488D-4263-B2E4-21C3224D6CCE}" dt="2023-09-22T12:43:19.327" v="7" actId="20577"/>
          <ac:spMkLst>
            <pc:docMk/>
            <pc:sldMk cId="1402241650" sldId="263"/>
            <ac:spMk id="2" creationId="{88AFF230-1DA5-46F7-BBA8-01E209F1227E}"/>
          </ac:spMkLst>
        </pc:spChg>
      </pc:sldChg>
      <pc:sldChg chg="modSp mod">
        <pc:chgData name="Mintzas, Konstantinos - SEG" userId="8c131287-7383-4bd1-a38f-81a83fd893f4" providerId="ADAL" clId="{159B6597-488D-4263-B2E4-21C3224D6CCE}" dt="2023-09-22T12:43:29.462" v="11" actId="20577"/>
        <pc:sldMkLst>
          <pc:docMk/>
          <pc:sldMk cId="300474881" sldId="268"/>
        </pc:sldMkLst>
        <pc:spChg chg="mod">
          <ac:chgData name="Mintzas, Konstantinos - SEG" userId="8c131287-7383-4bd1-a38f-81a83fd893f4" providerId="ADAL" clId="{159B6597-488D-4263-B2E4-21C3224D6CCE}" dt="2023-09-22T12:43:29.462" v="11" actId="20577"/>
          <ac:spMkLst>
            <pc:docMk/>
            <pc:sldMk cId="300474881" sldId="268"/>
            <ac:spMk id="2" creationId="{3AFC5EFF-5D9B-4DE4-96B7-1ED588E024FD}"/>
          </ac:spMkLst>
        </pc:spChg>
      </pc:sldChg>
      <pc:sldChg chg="modSp mod">
        <pc:chgData name="Mintzas, Konstantinos - SEG" userId="8c131287-7383-4bd1-a38f-81a83fd893f4" providerId="ADAL" clId="{159B6597-488D-4263-B2E4-21C3224D6CCE}" dt="2023-09-22T12:43:33.325" v="13" actId="20577"/>
        <pc:sldMkLst>
          <pc:docMk/>
          <pc:sldMk cId="3678178586" sldId="269"/>
        </pc:sldMkLst>
        <pc:spChg chg="mod">
          <ac:chgData name="Mintzas, Konstantinos - SEG" userId="8c131287-7383-4bd1-a38f-81a83fd893f4" providerId="ADAL" clId="{159B6597-488D-4263-B2E4-21C3224D6CCE}" dt="2023-09-22T12:43:33.325" v="13" actId="20577"/>
          <ac:spMkLst>
            <pc:docMk/>
            <pc:sldMk cId="3678178586" sldId="269"/>
            <ac:spMk id="2" creationId="{88AFF230-1DA5-46F7-BBA8-01E209F1227E}"/>
          </ac:spMkLst>
        </pc:spChg>
      </pc:sldChg>
      <pc:sldChg chg="delSp modSp mod ord">
        <pc:chgData name="Mintzas, Konstantinos - SEG" userId="8c131287-7383-4bd1-a38f-81a83fd893f4" providerId="ADAL" clId="{159B6597-488D-4263-B2E4-21C3224D6CCE}" dt="2023-09-22T12:43:24.313" v="9" actId="20577"/>
        <pc:sldMkLst>
          <pc:docMk/>
          <pc:sldMk cId="933156335" sldId="270"/>
        </pc:sldMkLst>
        <pc:spChg chg="mod">
          <ac:chgData name="Mintzas, Konstantinos - SEG" userId="8c131287-7383-4bd1-a38f-81a83fd893f4" providerId="ADAL" clId="{159B6597-488D-4263-B2E4-21C3224D6CCE}" dt="2023-09-22T12:43:24.313" v="9" actId="20577"/>
          <ac:spMkLst>
            <pc:docMk/>
            <pc:sldMk cId="933156335" sldId="270"/>
            <ac:spMk id="2" creationId="{8FD1F06E-C9AA-441C-973A-D61A9E2B8453}"/>
          </ac:spMkLst>
        </pc:spChg>
        <pc:spChg chg="del">
          <ac:chgData name="Mintzas, Konstantinos - SEG" userId="8c131287-7383-4bd1-a38f-81a83fd893f4" providerId="ADAL" clId="{159B6597-488D-4263-B2E4-21C3224D6CCE}" dt="2023-09-22T12:41:24.642" v="0" actId="478"/>
          <ac:spMkLst>
            <pc:docMk/>
            <pc:sldMk cId="933156335" sldId="270"/>
            <ac:spMk id="11" creationId="{961071D5-0E59-4DD9-88F2-4D920B511A5A}"/>
          </ac:spMkLst>
        </pc:spChg>
        <pc:spChg chg="del">
          <ac:chgData name="Mintzas, Konstantinos - SEG" userId="8c131287-7383-4bd1-a38f-81a83fd893f4" providerId="ADAL" clId="{159B6597-488D-4263-B2E4-21C3224D6CCE}" dt="2023-09-22T12:41:24.642" v="0" actId="478"/>
          <ac:spMkLst>
            <pc:docMk/>
            <pc:sldMk cId="933156335" sldId="270"/>
            <ac:spMk id="13" creationId="{1880C785-DEE7-4F2D-A74A-BD7A8D21CF19}"/>
          </ac:spMkLst>
        </pc:spChg>
        <pc:spChg chg="del">
          <ac:chgData name="Mintzas, Konstantinos - SEG" userId="8c131287-7383-4bd1-a38f-81a83fd893f4" providerId="ADAL" clId="{159B6597-488D-4263-B2E4-21C3224D6CCE}" dt="2023-09-22T12:41:24.642" v="0" actId="478"/>
          <ac:spMkLst>
            <pc:docMk/>
            <pc:sldMk cId="933156335" sldId="270"/>
            <ac:spMk id="14" creationId="{D0917230-A709-499D-A55C-3C8D68CFAE52}"/>
          </ac:spMkLst>
        </pc:spChg>
        <pc:picChg chg="del">
          <ac:chgData name="Mintzas, Konstantinos - SEG" userId="8c131287-7383-4bd1-a38f-81a83fd893f4" providerId="ADAL" clId="{159B6597-488D-4263-B2E4-21C3224D6CCE}" dt="2023-09-22T12:41:24.642" v="0" actId="478"/>
          <ac:picMkLst>
            <pc:docMk/>
            <pc:sldMk cId="933156335" sldId="270"/>
            <ac:picMk id="12" creationId="{94E295F6-5AC6-40EB-868C-E403858784F2}"/>
          </ac:picMkLst>
        </pc:picChg>
        <pc:picChg chg="del">
          <ac:chgData name="Mintzas, Konstantinos - SEG" userId="8c131287-7383-4bd1-a38f-81a83fd893f4" providerId="ADAL" clId="{159B6597-488D-4263-B2E4-21C3224D6CCE}" dt="2023-09-22T12:41:24.642" v="0" actId="478"/>
          <ac:picMkLst>
            <pc:docMk/>
            <pc:sldMk cId="933156335" sldId="270"/>
            <ac:picMk id="15" creationId="{BD78FABC-D48F-4D7D-A4B6-37F427A959A2}"/>
          </ac:picMkLst>
        </pc:picChg>
        <pc:picChg chg="del">
          <ac:chgData name="Mintzas, Konstantinos - SEG" userId="8c131287-7383-4bd1-a38f-81a83fd893f4" providerId="ADAL" clId="{159B6597-488D-4263-B2E4-21C3224D6CCE}" dt="2023-09-22T12:41:24.642" v="0" actId="478"/>
          <ac:picMkLst>
            <pc:docMk/>
            <pc:sldMk cId="933156335" sldId="270"/>
            <ac:picMk id="16" creationId="{1EAAC67D-359B-45DC-A059-46456E65DD18}"/>
          </ac:picMkLst>
        </pc:picChg>
      </pc:sldChg>
    </pc:docChg>
  </pc:docChgLst>
  <pc:docChgLst>
    <pc:chgData name="Mintzas, Konstantinos - SEG" userId="8c131287-7383-4bd1-a38f-81a83fd893f4" providerId="ADAL" clId="{98F8FE66-6ABD-48C7-BB06-B31C1A06B5A1}"/>
    <pc:docChg chg="modSld">
      <pc:chgData name="Mintzas, Konstantinos - SEG" userId="8c131287-7383-4bd1-a38f-81a83fd893f4" providerId="ADAL" clId="{98F8FE66-6ABD-48C7-BB06-B31C1A06B5A1}" dt="2023-08-10T08:46:37.903" v="0" actId="404"/>
      <pc:docMkLst>
        <pc:docMk/>
      </pc:docMkLst>
      <pc:sldChg chg="modSp mod">
        <pc:chgData name="Mintzas, Konstantinos - SEG" userId="8c131287-7383-4bd1-a38f-81a83fd893f4" providerId="ADAL" clId="{98F8FE66-6ABD-48C7-BB06-B31C1A06B5A1}" dt="2023-08-10T08:46:37.903" v="0" actId="404"/>
        <pc:sldMkLst>
          <pc:docMk/>
          <pc:sldMk cId="900528703" sldId="261"/>
        </pc:sldMkLst>
        <pc:spChg chg="mod">
          <ac:chgData name="Mintzas, Konstantinos - SEG" userId="8c131287-7383-4bd1-a38f-81a83fd893f4" providerId="ADAL" clId="{98F8FE66-6ABD-48C7-BB06-B31C1A06B5A1}" dt="2023-08-10T08:46:37.903" v="0" actId="404"/>
          <ac:spMkLst>
            <pc:docMk/>
            <pc:sldMk cId="900528703" sldId="261"/>
            <ac:spMk id="2" creationId="{CACD1F2C-E15C-4C16-BE44-24A3E67BC1DD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799FA-455A-429D-BD37-1DDCA2271E9C}" type="datetimeFigureOut">
              <a:rPr lang="en-GB" smtClean="0"/>
              <a:t>16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C982D-0BB2-447D-9233-EFBA3C639C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70006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799FA-455A-429D-BD37-1DDCA2271E9C}" type="datetimeFigureOut">
              <a:rPr lang="en-GB" smtClean="0"/>
              <a:t>16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C982D-0BB2-447D-9233-EFBA3C639C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51923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799FA-455A-429D-BD37-1DDCA2271E9C}" type="datetimeFigureOut">
              <a:rPr lang="en-GB" smtClean="0"/>
              <a:t>16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C982D-0BB2-447D-9233-EFBA3C639C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76598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799FA-455A-429D-BD37-1DDCA2271E9C}" type="datetimeFigureOut">
              <a:rPr lang="en-GB" smtClean="0"/>
              <a:t>16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C982D-0BB2-447D-9233-EFBA3C639C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60882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799FA-455A-429D-BD37-1DDCA2271E9C}" type="datetimeFigureOut">
              <a:rPr lang="en-GB" smtClean="0"/>
              <a:t>16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C982D-0BB2-447D-9233-EFBA3C639C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23126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799FA-455A-429D-BD37-1DDCA2271E9C}" type="datetimeFigureOut">
              <a:rPr lang="en-GB" smtClean="0"/>
              <a:t>16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C982D-0BB2-447D-9233-EFBA3C639C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87735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799FA-455A-429D-BD37-1DDCA2271E9C}" type="datetimeFigureOut">
              <a:rPr lang="en-GB" smtClean="0"/>
              <a:t>16/11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C982D-0BB2-447D-9233-EFBA3C639C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7573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799FA-455A-429D-BD37-1DDCA2271E9C}" type="datetimeFigureOut">
              <a:rPr lang="en-GB" smtClean="0"/>
              <a:t>16/11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C982D-0BB2-447D-9233-EFBA3C639C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826285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799FA-455A-429D-BD37-1DDCA2271E9C}" type="datetimeFigureOut">
              <a:rPr lang="en-GB" smtClean="0"/>
              <a:t>16/11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C982D-0BB2-447D-9233-EFBA3C639C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49694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799FA-455A-429D-BD37-1DDCA2271E9C}" type="datetimeFigureOut">
              <a:rPr lang="en-GB" smtClean="0"/>
              <a:t>16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C982D-0BB2-447D-9233-EFBA3C639C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73563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799FA-455A-429D-BD37-1DDCA2271E9C}" type="datetimeFigureOut">
              <a:rPr lang="en-GB" smtClean="0"/>
              <a:t>16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C982D-0BB2-447D-9233-EFBA3C639C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3456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C799FA-455A-429D-BD37-1DDCA2271E9C}" type="datetimeFigureOut">
              <a:rPr lang="en-GB" smtClean="0"/>
              <a:t>16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9C982D-0BB2-447D-9233-EFBA3C639C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692854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EC7B67D-7798-4B42-8A08-520C694C9413}"/>
              </a:ext>
            </a:extLst>
          </p:cNvPr>
          <p:cNvSpPr txBox="1"/>
          <p:nvPr/>
        </p:nvSpPr>
        <p:spPr>
          <a:xfrm>
            <a:off x="542160" y="537282"/>
            <a:ext cx="5302862" cy="276999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n-GB" sz="1200" b="1">
                <a:latin typeface="Arial" panose="020B0604020202020204" pitchFamily="34" charset="0"/>
                <a:ea typeface="Tahoma"/>
                <a:cs typeface="Arial" panose="020B0604020202020204" pitchFamily="34" charset="0"/>
              </a:rPr>
              <a:t>Supplementary Table 1</a:t>
            </a:r>
            <a:r>
              <a:rPr lang="en-GB" sz="1200">
                <a:latin typeface="Arial" panose="020B0604020202020204" pitchFamily="34" charset="0"/>
                <a:ea typeface="Tahoma"/>
                <a:cs typeface="Arial" panose="020B0604020202020204" pitchFamily="34" charset="0"/>
              </a:rPr>
              <a:t>. Comparison study between XP-300 and XN-9000</a:t>
            </a:r>
            <a:endParaRPr lang="en-GB" sz="1200">
              <a:latin typeface="Arial" panose="020B0604020202020204" pitchFamily="34" charset="0"/>
              <a:ea typeface="Tahoma" panose="020B060403050404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Table 7">
            <a:extLst>
              <a:ext uri="{FF2B5EF4-FFF2-40B4-BE49-F238E27FC236}">
                <a16:creationId xmlns:a16="http://schemas.microsoft.com/office/drawing/2014/main" id="{65CE4B14-DFAE-452E-94E0-DE311C228A9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64307753"/>
              </p:ext>
            </p:extLst>
          </p:nvPr>
        </p:nvGraphicFramePr>
        <p:xfrm>
          <a:off x="607605" y="966065"/>
          <a:ext cx="5642788" cy="60960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83058">
                  <a:extLst>
                    <a:ext uri="{9D8B030D-6E8A-4147-A177-3AD203B41FA5}">
                      <a16:colId xmlns:a16="http://schemas.microsoft.com/office/drawing/2014/main" val="3982848305"/>
                    </a:ext>
                  </a:extLst>
                </a:gridCol>
                <a:gridCol w="672993">
                  <a:extLst>
                    <a:ext uri="{9D8B030D-6E8A-4147-A177-3AD203B41FA5}">
                      <a16:colId xmlns:a16="http://schemas.microsoft.com/office/drawing/2014/main" val="1902533349"/>
                    </a:ext>
                  </a:extLst>
                </a:gridCol>
                <a:gridCol w="934386">
                  <a:extLst>
                    <a:ext uri="{9D8B030D-6E8A-4147-A177-3AD203B41FA5}">
                      <a16:colId xmlns:a16="http://schemas.microsoft.com/office/drawing/2014/main" val="1247450781"/>
                    </a:ext>
                  </a:extLst>
                </a:gridCol>
                <a:gridCol w="1009934">
                  <a:extLst>
                    <a:ext uri="{9D8B030D-6E8A-4147-A177-3AD203B41FA5}">
                      <a16:colId xmlns:a16="http://schemas.microsoft.com/office/drawing/2014/main" val="3774681632"/>
                    </a:ext>
                  </a:extLst>
                </a:gridCol>
                <a:gridCol w="900752">
                  <a:extLst>
                    <a:ext uri="{9D8B030D-6E8A-4147-A177-3AD203B41FA5}">
                      <a16:colId xmlns:a16="http://schemas.microsoft.com/office/drawing/2014/main" val="3288147194"/>
                    </a:ext>
                  </a:extLst>
                </a:gridCol>
                <a:gridCol w="1241665">
                  <a:extLst>
                    <a:ext uri="{9D8B030D-6E8A-4147-A177-3AD203B41FA5}">
                      <a16:colId xmlns:a16="http://schemas.microsoft.com/office/drawing/2014/main" val="3481651427"/>
                    </a:ext>
                  </a:extLst>
                </a:gridCol>
              </a:tblGrid>
              <a:tr h="253693">
                <a:tc>
                  <a:txBody>
                    <a:bodyPr/>
                    <a:lstStyle/>
                    <a:p>
                      <a:pPr algn="ctr"/>
                      <a:endParaRPr lang="en-GB" sz="10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mple size</a:t>
                      </a:r>
                    </a:p>
                  </a:txBody>
                  <a:tcPr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rrelation coefficient</a:t>
                      </a:r>
                    </a:p>
                  </a:txBody>
                  <a:tcPr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cept</a:t>
                      </a:r>
                    </a:p>
                  </a:txBody>
                  <a:tcPr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ope</a:t>
                      </a:r>
                    </a:p>
                  </a:txBody>
                  <a:tcPr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fference of means (XN-XQ)</a:t>
                      </a:r>
                    </a:p>
                  </a:txBody>
                  <a:tcPr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28298368"/>
                  </a:ext>
                </a:extLst>
              </a:tr>
              <a:tr h="156119">
                <a:tc>
                  <a:txBody>
                    <a:bodyPr/>
                    <a:lstStyle/>
                    <a:p>
                      <a:r>
                        <a:rPr lang="en-GB" sz="10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BC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2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8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76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58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0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66994449"/>
                  </a:ext>
                </a:extLst>
              </a:tr>
              <a:tr h="156119">
                <a:tc>
                  <a:txBody>
                    <a:bodyPr/>
                    <a:lstStyle/>
                    <a:p>
                      <a:r>
                        <a:rPr lang="en-GB" sz="10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BC &lt; 3.5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87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50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6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97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79680999"/>
                  </a:ext>
                </a:extLst>
              </a:tr>
              <a:tr h="156119">
                <a:tc>
                  <a:txBody>
                    <a:bodyPr/>
                    <a:lstStyle/>
                    <a:p>
                      <a:r>
                        <a:rPr lang="en-GB" sz="1000" b="1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T#</a:t>
                      </a:r>
                      <a:r>
                        <a:rPr lang="en-GB" sz="1000" b="1" baseline="3000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GB" sz="10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2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8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2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81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09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02349025"/>
                  </a:ext>
                </a:extLst>
              </a:tr>
              <a:tr h="156119">
                <a:tc>
                  <a:txBody>
                    <a:bodyPr/>
                    <a:lstStyle/>
                    <a:p>
                      <a:r>
                        <a:rPr lang="en-GB" sz="10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YMPH#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6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58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60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4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52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29698126"/>
                  </a:ext>
                </a:extLst>
              </a:tr>
              <a:tr h="156119">
                <a:tc>
                  <a:txBody>
                    <a:bodyPr/>
                    <a:lstStyle/>
                    <a:p>
                      <a:r>
                        <a:rPr lang="en-GB" sz="1000" b="1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XD#</a:t>
                      </a:r>
                      <a:r>
                        <a:rPr lang="en-GB" sz="1000" b="1" baseline="3000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  <a:endParaRPr lang="en-GB" sz="10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6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10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5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02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3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37435356"/>
                  </a:ext>
                </a:extLst>
              </a:tr>
              <a:tr h="156119">
                <a:tc>
                  <a:txBody>
                    <a:bodyPr/>
                    <a:lstStyle/>
                    <a:p>
                      <a:r>
                        <a:rPr lang="en-GB" sz="1000" b="1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T%</a:t>
                      </a:r>
                      <a:r>
                        <a:rPr lang="en-GB" sz="1000" b="1" baseline="3000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GB" sz="10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8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88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03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6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45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137123976"/>
                  </a:ext>
                </a:extLst>
              </a:tr>
              <a:tr h="156119">
                <a:tc>
                  <a:txBody>
                    <a:bodyPr/>
                    <a:lstStyle/>
                    <a:p>
                      <a:r>
                        <a:rPr lang="en-GB" sz="10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YMPH%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89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15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15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570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03231350"/>
                  </a:ext>
                </a:extLst>
              </a:tr>
              <a:tr h="156119">
                <a:tc>
                  <a:txBody>
                    <a:bodyPr/>
                    <a:lstStyle/>
                    <a:p>
                      <a:r>
                        <a:rPr lang="en-GB" sz="1000" b="1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XD%</a:t>
                      </a:r>
                      <a:r>
                        <a:rPr lang="en-GB" sz="1000" b="1" baseline="3000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  <a:endParaRPr lang="en-GB" sz="1000" b="1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6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83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76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80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36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80716180"/>
                  </a:ext>
                </a:extLst>
              </a:tr>
              <a:tr h="156119">
                <a:tc>
                  <a:txBody>
                    <a:bodyPr/>
                    <a:lstStyle/>
                    <a:p>
                      <a:r>
                        <a:rPr lang="en-GB" sz="10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BC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6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9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5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58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1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96884756"/>
                  </a:ext>
                </a:extLst>
              </a:tr>
              <a:tr h="156119">
                <a:tc>
                  <a:txBody>
                    <a:bodyPr/>
                    <a:lstStyle/>
                    <a:p>
                      <a:r>
                        <a:rPr lang="en-GB" sz="10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GB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8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9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773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6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217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02413816"/>
                  </a:ext>
                </a:extLst>
              </a:tr>
              <a:tr h="156119">
                <a:tc>
                  <a:txBody>
                    <a:bodyPr/>
                    <a:lstStyle/>
                    <a:p>
                      <a:r>
                        <a:rPr lang="en-GB" sz="10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CT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6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7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49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51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10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320464"/>
                  </a:ext>
                </a:extLst>
              </a:tr>
              <a:tr h="156119">
                <a:tc>
                  <a:txBody>
                    <a:bodyPr/>
                    <a:lstStyle/>
                    <a:p>
                      <a:r>
                        <a:rPr lang="en-GB" sz="10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V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6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0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394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31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7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24819877"/>
                  </a:ext>
                </a:extLst>
              </a:tr>
              <a:tr h="156119">
                <a:tc>
                  <a:txBody>
                    <a:bodyPr/>
                    <a:lstStyle/>
                    <a:p>
                      <a:r>
                        <a:rPr lang="en-GB" sz="10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H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88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15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8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53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99685481"/>
                  </a:ext>
                </a:extLst>
              </a:tr>
              <a:tr h="156119">
                <a:tc>
                  <a:txBody>
                    <a:bodyPr/>
                    <a:lstStyle/>
                    <a:p>
                      <a:r>
                        <a:rPr lang="en-GB" sz="10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HC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0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.984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20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.768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44826506"/>
                  </a:ext>
                </a:extLst>
              </a:tr>
              <a:tr h="156119">
                <a:tc>
                  <a:txBody>
                    <a:bodyPr/>
                    <a:lstStyle/>
                    <a:p>
                      <a:r>
                        <a:rPr lang="en-GB" sz="10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DW-SD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6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5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757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58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353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65145092"/>
                  </a:ext>
                </a:extLst>
              </a:tr>
              <a:tr h="156119">
                <a:tc>
                  <a:txBody>
                    <a:bodyPr/>
                    <a:lstStyle/>
                    <a:p>
                      <a:r>
                        <a:rPr lang="en-GB" sz="10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DW-CV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6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8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38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6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70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79306567"/>
                  </a:ext>
                </a:extLst>
              </a:tr>
              <a:tr h="156119">
                <a:tc>
                  <a:txBody>
                    <a:bodyPr/>
                    <a:lstStyle/>
                    <a:p>
                      <a:r>
                        <a:rPr lang="en-GB" sz="10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T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9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5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8.845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65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7.877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02138032"/>
                  </a:ext>
                </a:extLst>
              </a:tr>
              <a:tr h="156119">
                <a:tc>
                  <a:txBody>
                    <a:bodyPr/>
                    <a:lstStyle/>
                    <a:p>
                      <a:r>
                        <a:rPr lang="en-GB" sz="10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T &lt; 150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86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4.556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48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3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567806014"/>
                  </a:ext>
                </a:extLst>
              </a:tr>
              <a:tr h="156119">
                <a:tc>
                  <a:txBody>
                    <a:bodyPr/>
                    <a:lstStyle/>
                    <a:p>
                      <a:r>
                        <a:rPr lang="en-GB" sz="10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W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8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03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97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56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668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5968197"/>
                  </a:ext>
                </a:extLst>
              </a:tr>
              <a:tr h="156119">
                <a:tc>
                  <a:txBody>
                    <a:bodyPr/>
                    <a:lstStyle/>
                    <a:p>
                      <a:r>
                        <a:rPr lang="en-GB" sz="10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PV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8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31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183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75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26820773"/>
                  </a:ext>
                </a:extLst>
              </a:tr>
              <a:tr h="156119">
                <a:tc>
                  <a:txBody>
                    <a:bodyPr/>
                    <a:lstStyle/>
                    <a:p>
                      <a:r>
                        <a:rPr lang="en-GB" sz="10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LCR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8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58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030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31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59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50181068"/>
                  </a:ext>
                </a:extLst>
              </a:tr>
              <a:tr h="156119">
                <a:tc>
                  <a:txBody>
                    <a:bodyPr/>
                    <a:lstStyle/>
                    <a:p>
                      <a:r>
                        <a:rPr lang="en-GB" sz="10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T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8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4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06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07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5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551984926"/>
                  </a:ext>
                </a:extLst>
              </a:tr>
              <a:tr h="156119">
                <a:tc gridSpan="6">
                  <a:txBody>
                    <a:bodyPr/>
                    <a:lstStyle/>
                    <a:p>
                      <a:r>
                        <a:rPr lang="en-GB" sz="800" baseline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. For comparison studies, NEUT#/% on XN-9000 derived from the 5-part DIFF setting; IG#/% were included in NEUT.</a:t>
                      </a:r>
                    </a:p>
                    <a:p>
                      <a:r>
                        <a:rPr lang="en-GB" sz="800" baseline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. For</a:t>
                      </a:r>
                      <a:r>
                        <a:rPr lang="en-GB" sz="8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omparison studies, MXD#/% on XN-9000 is calculated as MONO+BASO+EO.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GB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GB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GB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GB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GB" sz="10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0420198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9036220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28</Words>
  <Application>Microsoft Office PowerPoint</Application>
  <PresentationFormat>A4 Paper (210x297 mm)</PresentationFormat>
  <Paragraphs>14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ntzas, Konstantinos - SEG</dc:creator>
  <cp:lastModifiedBy>Mintzas, Konstantinos - SEG</cp:lastModifiedBy>
  <cp:revision>1</cp:revision>
  <dcterms:created xsi:type="dcterms:W3CDTF">2023-05-24T09:16:26Z</dcterms:created>
  <dcterms:modified xsi:type="dcterms:W3CDTF">2023-11-16T09:28:4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6130f3e2-7a1d-4dd6-b4ca-096bea8b9aeb_Enabled">
    <vt:lpwstr>true</vt:lpwstr>
  </property>
  <property fmtid="{D5CDD505-2E9C-101B-9397-08002B2CF9AE}" pid="3" name="MSIP_Label_6130f3e2-7a1d-4dd6-b4ca-096bea8b9aeb_SetDate">
    <vt:lpwstr>2023-11-16T09:28:35Z</vt:lpwstr>
  </property>
  <property fmtid="{D5CDD505-2E9C-101B-9397-08002B2CF9AE}" pid="4" name="MSIP_Label_6130f3e2-7a1d-4dd6-b4ca-096bea8b9aeb_Method">
    <vt:lpwstr>Privileged</vt:lpwstr>
  </property>
  <property fmtid="{D5CDD505-2E9C-101B-9397-08002B2CF9AE}" pid="5" name="MSIP_Label_6130f3e2-7a1d-4dd6-b4ca-096bea8b9aeb_Name">
    <vt:lpwstr>Public</vt:lpwstr>
  </property>
  <property fmtid="{D5CDD505-2E9C-101B-9397-08002B2CF9AE}" pid="6" name="MSIP_Label_6130f3e2-7a1d-4dd6-b4ca-096bea8b9aeb_SiteId">
    <vt:lpwstr>66b9ec7f-68a6-4d5b-a8fe-a7bac3927e7c</vt:lpwstr>
  </property>
  <property fmtid="{D5CDD505-2E9C-101B-9397-08002B2CF9AE}" pid="7" name="MSIP_Label_6130f3e2-7a1d-4dd6-b4ca-096bea8b9aeb_ActionId">
    <vt:lpwstr>e6d71a66-fe7c-4cc8-8c28-e8aac65193ad</vt:lpwstr>
  </property>
  <property fmtid="{D5CDD505-2E9C-101B-9397-08002B2CF9AE}" pid="8" name="MSIP_Label_6130f3e2-7a1d-4dd6-b4ca-096bea8b9aeb_ContentBits">
    <vt:lpwstr>0</vt:lpwstr>
  </property>
</Properties>
</file>